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93" r:id="rId2"/>
    <p:sldId id="287" r:id="rId3"/>
    <p:sldId id="288" r:id="rId4"/>
    <p:sldId id="289" r:id="rId5"/>
    <p:sldId id="259" r:id="rId6"/>
    <p:sldId id="269" r:id="rId7"/>
    <p:sldId id="270" r:id="rId8"/>
    <p:sldId id="273" r:id="rId9"/>
    <p:sldId id="272" r:id="rId10"/>
    <p:sldId id="274" r:id="rId11"/>
    <p:sldId id="278" r:id="rId12"/>
    <p:sldId id="277" r:id="rId13"/>
    <p:sldId id="268" r:id="rId14"/>
    <p:sldId id="276" r:id="rId15"/>
    <p:sldId id="284" r:id="rId16"/>
    <p:sldId id="305" r:id="rId17"/>
    <p:sldId id="300" r:id="rId18"/>
    <p:sldId id="301" r:id="rId19"/>
    <p:sldId id="302" r:id="rId20"/>
    <p:sldId id="303" r:id="rId21"/>
    <p:sldId id="304" r:id="rId22"/>
    <p:sldId id="295" r:id="rId23"/>
    <p:sldId id="296" r:id="rId24"/>
    <p:sldId id="298" r:id="rId25"/>
    <p:sldId id="297" r:id="rId26"/>
    <p:sldId id="299" r:id="rId27"/>
    <p:sldId id="306" r:id="rId28"/>
    <p:sldId id="307" r:id="rId29"/>
  </p:sldIdLst>
  <p:sldSz cx="9906000" cy="13208000"/>
  <p:notesSz cx="6797675" cy="9928225"/>
  <p:defaultTextStyle>
    <a:defPPr>
      <a:defRPr lang="ko-KR"/>
    </a:defPPr>
    <a:lvl1pPr marL="0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1pPr>
    <a:lvl2pPr marL="599023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2pPr>
    <a:lvl3pPr marL="1198047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3pPr>
    <a:lvl4pPr marL="1797070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4pPr>
    <a:lvl5pPr marL="2396094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5pPr>
    <a:lvl6pPr marL="2995117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6pPr>
    <a:lvl7pPr marL="3594141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7pPr>
    <a:lvl8pPr marL="4193164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8pPr>
    <a:lvl9pPr marL="4792188" algn="l" defTabSz="1198047" rtl="0" eaLnBrk="1" latinLnBrk="1" hangingPunct="1">
      <a:defRPr sz="235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45" userDrawn="1">
          <p15:clr>
            <a:srgbClr val="A4A3A4"/>
          </p15:clr>
        </p15:guide>
        <p15:guide id="2" pos="3120" userDrawn="1">
          <p15:clr>
            <a:srgbClr val="A4A3A4"/>
          </p15:clr>
        </p15:guide>
        <p15:guide id="3" pos="240" userDrawn="1">
          <p15:clr>
            <a:srgbClr val="A4A3A4"/>
          </p15:clr>
        </p15:guide>
        <p15:guide id="4" orient="horz" pos="168" userDrawn="1">
          <p15:clr>
            <a:srgbClr val="A4A3A4"/>
          </p15:clr>
        </p15:guide>
        <p15:guide id="5" pos="3347" userDrawn="1">
          <p15:clr>
            <a:srgbClr val="A4A3A4"/>
          </p15:clr>
        </p15:guide>
        <p15:guide id="6" pos="557" userDrawn="1">
          <p15:clr>
            <a:srgbClr val="A4A3A4"/>
          </p15:clr>
        </p15:guide>
        <p15:guide id="7" pos="5887" userDrawn="1">
          <p15:clr>
            <a:srgbClr val="A4A3A4"/>
          </p15:clr>
        </p15:guide>
        <p15:guide id="8" orient="horz" pos="4772" userDrawn="1">
          <p15:clr>
            <a:srgbClr val="A4A3A4"/>
          </p15:clr>
        </p15:guide>
        <p15:guide id="9" orient="horz" pos="849" userDrawn="1">
          <p15:clr>
            <a:srgbClr val="A4A3A4"/>
          </p15:clr>
        </p15:guide>
        <p15:guide id="10" orient="horz" pos="338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EE499AE-A579-41C7-B5A0-5C8C073537EF}" v="1" dt="2021-08-05T08:45:20.53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보통 스타일 3 - 강조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보통 스타일 3 - 강조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EC20E35-A176-4012-BC5E-935CFFF8708E}" styleName="보통 스타일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5BE263C-DBD7-4A20-BB59-AAB30ACAA65A}" styleName="보통 스타일 3 - 강조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793D81CF-94F2-401A-BA57-92F5A7B2D0C5}" styleName="보통 스타일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83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3126" y="96"/>
      </p:cViewPr>
      <p:guideLst>
        <p:guide orient="horz" pos="645"/>
        <p:guide pos="3120"/>
        <p:guide pos="240"/>
        <p:guide orient="horz" pos="168"/>
        <p:guide pos="3347"/>
        <p:guide pos="557"/>
        <p:guide pos="5887"/>
        <p:guide orient="horz" pos="4772"/>
        <p:guide orient="horz" pos="849"/>
        <p:guide orient="horz" pos="338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microsoft.com/office/2016/11/relationships/changesInfo" Target="changesInfos/changesInfo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presProps" Target="presProps.xml"/><Relationship Id="rId35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u Seung-Yup" userId="dc216b2ecdfe7d16" providerId="LiveId" clId="{1EE499AE-A579-41C7-B5A0-5C8C073537EF}"/>
    <pc:docChg chg="addSld modSld">
      <pc:chgData name="Ku Seung-Yup" userId="dc216b2ecdfe7d16" providerId="LiveId" clId="{1EE499AE-A579-41C7-B5A0-5C8C073537EF}" dt="2021-08-05T08:45:20.534" v="0"/>
      <pc:docMkLst>
        <pc:docMk/>
      </pc:docMkLst>
      <pc:sldChg chg="add">
        <pc:chgData name="Ku Seung-Yup" userId="dc216b2ecdfe7d16" providerId="LiveId" clId="{1EE499AE-A579-41C7-B5A0-5C8C073537EF}" dt="2021-08-05T08:45:20.534" v="0"/>
        <pc:sldMkLst>
          <pc:docMk/>
          <pc:sldMk cId="2800385082" sldId="259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478589639" sldId="268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2572340831" sldId="269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631540902" sldId="270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3488203401" sldId="272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1784837458" sldId="273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1767717425" sldId="274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1045333791" sldId="276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1911585405" sldId="277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3605129852" sldId="278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857006570" sldId="284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4039363849" sldId="287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2944508367" sldId="288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2918491810" sldId="289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4174035569" sldId="293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2480131690" sldId="295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1140783228" sldId="296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2568796812" sldId="297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2684181940" sldId="298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1511930391" sldId="299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3547915476" sldId="300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2913616755" sldId="301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1971211963" sldId="302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794972324" sldId="303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3771467880" sldId="304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632005521" sldId="305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960762415" sldId="306"/>
        </pc:sldMkLst>
      </pc:sldChg>
      <pc:sldChg chg="add">
        <pc:chgData name="Ku Seung-Yup" userId="dc216b2ecdfe7d16" providerId="LiveId" clId="{1EE499AE-A579-41C7-B5A0-5C8C073537EF}" dt="2021-08-05T08:45:20.534" v="0"/>
        <pc:sldMkLst>
          <pc:docMk/>
          <pc:sldMk cId="509648184" sldId="30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61588"/>
            <a:ext cx="8420100" cy="4598341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6937258"/>
            <a:ext cx="7429500" cy="3188875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1644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4058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703204"/>
            <a:ext cx="2135981" cy="11193169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703204"/>
            <a:ext cx="6284119" cy="11193169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5637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6713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3292832"/>
            <a:ext cx="8543925" cy="5494160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8838969"/>
            <a:ext cx="8543925" cy="2889249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0069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3516018"/>
            <a:ext cx="4210050" cy="838035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3516018"/>
            <a:ext cx="4210050" cy="838035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4326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703207"/>
            <a:ext cx="8543925" cy="255293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3237796"/>
            <a:ext cx="4190702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4824589"/>
            <a:ext cx="4190702" cy="709624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3237796"/>
            <a:ext cx="4211340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4824589"/>
            <a:ext cx="4211340" cy="709624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0073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4728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8231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901710"/>
            <a:ext cx="5014913" cy="9386241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73436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901710"/>
            <a:ext cx="5014913" cy="9386241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2018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703207"/>
            <a:ext cx="8543925" cy="2552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3516018"/>
            <a:ext cx="8543925" cy="83803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6949E6-B403-40D4-876B-925D6743249B}" type="datetimeFigureOut">
              <a:rPr lang="ko-KR" altLang="en-US" smtClean="0"/>
              <a:t>2021-10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12241862"/>
            <a:ext cx="3343275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DC092-4ECD-473C-B0C2-2534635FD2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3940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90570" rtl="0" eaLnBrk="1" latinLnBrk="1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1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1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1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2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7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2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5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8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1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7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0.png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png"/><Relationship Id="rId3" Type="http://schemas.openxmlformats.org/officeDocument/2006/relationships/image" Target="../media/image62.png"/><Relationship Id="rId7" Type="http://schemas.openxmlformats.org/officeDocument/2006/relationships/image" Target="../media/image66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5.png"/><Relationship Id="rId5" Type="http://schemas.openxmlformats.org/officeDocument/2006/relationships/image" Target="../media/image64.png"/><Relationship Id="rId4" Type="http://schemas.openxmlformats.org/officeDocument/2006/relationships/image" Target="../media/image63.png"/><Relationship Id="rId9" Type="http://schemas.openxmlformats.org/officeDocument/2006/relationships/image" Target="../media/image68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7" Type="http://schemas.openxmlformats.org/officeDocument/2006/relationships/image" Target="../media/image74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3.png"/><Relationship Id="rId5" Type="http://schemas.openxmlformats.org/officeDocument/2006/relationships/image" Target="../media/image72.png"/><Relationship Id="rId4" Type="http://schemas.openxmlformats.org/officeDocument/2006/relationships/image" Target="../media/image71.png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1.png"/><Relationship Id="rId3" Type="http://schemas.openxmlformats.org/officeDocument/2006/relationships/image" Target="../media/image76.png"/><Relationship Id="rId7" Type="http://schemas.openxmlformats.org/officeDocument/2006/relationships/image" Target="../media/image80.png"/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9.png"/><Relationship Id="rId5" Type="http://schemas.openxmlformats.org/officeDocument/2006/relationships/image" Target="../media/image78.png"/><Relationship Id="rId4" Type="http://schemas.openxmlformats.org/officeDocument/2006/relationships/image" Target="../media/image77.png"/><Relationship Id="rId9" Type="http://schemas.openxmlformats.org/officeDocument/2006/relationships/image" Target="../media/image82.png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87.png"/><Relationship Id="rId3" Type="http://schemas.openxmlformats.org/officeDocument/2006/relationships/image" Target="../media/image84.png"/><Relationship Id="rId7" Type="http://schemas.openxmlformats.org/officeDocument/2006/relationships/image" Target="../media/image86.png"/><Relationship Id="rId2" Type="http://schemas.openxmlformats.org/officeDocument/2006/relationships/image" Target="../media/image8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4.png"/><Relationship Id="rId5" Type="http://schemas.openxmlformats.org/officeDocument/2006/relationships/image" Target="../media/image85.png"/><Relationship Id="rId4" Type="http://schemas.openxmlformats.org/officeDocument/2006/relationships/image" Target="../media/image65.png"/><Relationship Id="rId9" Type="http://schemas.openxmlformats.org/officeDocument/2006/relationships/image" Target="../media/image88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image" Target="../media/image8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2.png"/><Relationship Id="rId5" Type="http://schemas.openxmlformats.org/officeDocument/2006/relationships/image" Target="../media/image91.png"/><Relationship Id="rId4" Type="http://schemas.openxmlformats.org/officeDocument/2006/relationships/image" Target="../media/image90.pn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4.png"/><Relationship Id="rId2" Type="http://schemas.openxmlformats.org/officeDocument/2006/relationships/image" Target="../media/image9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6.png"/><Relationship Id="rId4" Type="http://schemas.openxmlformats.org/officeDocument/2006/relationships/image" Target="../media/image95.pn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8.png"/><Relationship Id="rId2" Type="http://schemas.openxmlformats.org/officeDocument/2006/relationships/image" Target="../media/image9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1.png"/><Relationship Id="rId5" Type="http://schemas.openxmlformats.org/officeDocument/2006/relationships/image" Target="../media/image100.png"/><Relationship Id="rId4" Type="http://schemas.openxmlformats.org/officeDocument/2006/relationships/image" Target="../media/image9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KSY\Desktop\rq1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9802" y="1561654"/>
            <a:ext cx="4069454" cy="298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C:\Users\KSY\Desktop\rq2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7717" y="1561653"/>
            <a:ext cx="3947036" cy="298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 descr="C:\Users\KSY\Desktop\rq3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889" y="5409671"/>
            <a:ext cx="4139544" cy="302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3" descr="C:\Users\KSY\Desktop\rq4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7717" y="5407220"/>
            <a:ext cx="3902415" cy="295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81001" y="274651"/>
            <a:ext cx="9075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1. Read quality of transcripts.</a:t>
            </a:r>
            <a:endParaRPr lang="ko-KR" altLang="en-US" sz="18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563529" y="1126507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</a:t>
            </a:r>
            <a:endParaRPr lang="ko-KR" alt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5362370" y="1119416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B</a:t>
            </a:r>
            <a:endParaRPr lang="ko-KR" altLang="en-US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563529" y="4888882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C</a:t>
            </a:r>
            <a:endParaRPr lang="ko-KR" alt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5362370" y="4881791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41740355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9427" y="5052721"/>
            <a:ext cx="8890220" cy="3818022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9427" y="1192452"/>
            <a:ext cx="8909933" cy="368380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78192" y="1161087"/>
            <a:ext cx="1501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a) 20W vs 15W_all</a:t>
            </a:r>
            <a:endParaRPr lang="ko-KR" alt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F</a:t>
            </a:r>
            <a:endParaRPr lang="ko-KR" alt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971102" y="5033478"/>
            <a:ext cx="1467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) 20W vs 15W_up</a:t>
            </a:r>
            <a:endParaRPr lang="ko-KR" altLang="en-US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81001" y="274651"/>
            <a:ext cx="7082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4. GOBP analyses of the reproductively-aged mouse ovary. </a:t>
            </a:r>
            <a:endParaRPr lang="ko-KR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176771742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81001" y="274651"/>
            <a:ext cx="7936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5. GOMF analyses of the reproductively-aged mouse ovary. </a:t>
            </a:r>
            <a:endParaRPr lang="ko-KR" altLang="en-US" sz="18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</a:t>
            </a:r>
            <a:endParaRPr lang="ko-KR" altLang="en-US" sz="1400" b="1" dirty="0"/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0" y="1255875"/>
            <a:ext cx="8590548" cy="282717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681112" y="2444082"/>
            <a:ext cx="1467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20W vs 2W_up</a:t>
            </a:r>
            <a:endParaRPr lang="ko-KR" altLang="en-US" sz="1200" b="1" dirty="0"/>
          </a:p>
        </p:txBody>
      </p:sp>
      <p:pic>
        <p:nvPicPr>
          <p:cNvPr id="8" name="그림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7062" y="8622631"/>
            <a:ext cx="8518358" cy="3302000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237" y="4712364"/>
            <a:ext cx="8801183" cy="3192379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7681112" y="5692610"/>
            <a:ext cx="1467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a) 20W vs 6W_all</a:t>
            </a:r>
            <a:endParaRPr lang="ko-KR" altLang="en-US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563529" y="4426222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B</a:t>
            </a:r>
            <a:endParaRPr lang="ko-KR" alt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7677099" y="9815439"/>
            <a:ext cx="1467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) 20W vs 6W_up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60512985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13" y="4953000"/>
            <a:ext cx="9669225" cy="330200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488" y="1068427"/>
            <a:ext cx="9361250" cy="3302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C</a:t>
            </a:r>
            <a:endParaRPr lang="ko-KR" alt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7681112" y="1240926"/>
            <a:ext cx="1467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a) 20W vs 15W_all</a:t>
            </a:r>
            <a:endParaRPr lang="ko-KR" altLang="en-US" sz="12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701163" y="5123121"/>
            <a:ext cx="1467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) 20W vs 15W_up</a:t>
            </a:r>
            <a:endParaRPr lang="ko-KR" altLang="en-US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81001" y="274651"/>
            <a:ext cx="7936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5. GOMF analyses of the reproductively-aged mouse ovary. </a:t>
            </a:r>
            <a:endParaRPr lang="ko-KR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191158540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238" y="5186509"/>
            <a:ext cx="8849310" cy="3632637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81001" y="274651"/>
            <a:ext cx="7936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6. GOCC analyses of the reproductively-aged mouse ovary. </a:t>
            </a:r>
            <a:endParaRPr lang="ko-KR" altLang="en-US" sz="1800" b="1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238" y="1042737"/>
            <a:ext cx="8849310" cy="386614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839549" y="1237001"/>
            <a:ext cx="1501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a) 15W vs 2W_all</a:t>
            </a:r>
            <a:endParaRPr lang="ko-KR" altLang="en-US" sz="1200" b="1" dirty="0"/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238" y="9096771"/>
            <a:ext cx="8851043" cy="352926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</a:t>
            </a:r>
            <a:endParaRPr lang="ko-KR" alt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7835537" y="5371857"/>
            <a:ext cx="1501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) 15W vs 2W_up</a:t>
            </a:r>
            <a:endParaRPr lang="ko-KR" altLang="en-US" sz="12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835536" y="9273010"/>
            <a:ext cx="1501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) 15W vs 2W_down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47858963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235" y="1199140"/>
            <a:ext cx="8825249" cy="289594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71105" y="1346530"/>
            <a:ext cx="1501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a) 20W vs 2W_all</a:t>
            </a:r>
            <a:endParaRPr lang="ko-KR" altLang="en-US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B</a:t>
            </a:r>
            <a:endParaRPr lang="ko-KR" altLang="en-US" sz="1400" b="1" dirty="0"/>
          </a:p>
        </p:txBody>
      </p:sp>
      <p:pic>
        <p:nvPicPr>
          <p:cNvPr id="16" name="그림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238" y="4940962"/>
            <a:ext cx="8825246" cy="33020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7835536" y="5110081"/>
            <a:ext cx="1501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) 20W vs 2W_down</a:t>
            </a:r>
            <a:endParaRPr lang="ko-KR" alt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81001" y="274651"/>
            <a:ext cx="7936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6. GOCC analyses of the reproductively-aged mouse ovary. </a:t>
            </a:r>
            <a:endParaRPr lang="ko-KR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104533379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984" y="1905416"/>
            <a:ext cx="8885405" cy="341505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7574852" y="2088745"/>
            <a:ext cx="1501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a) 15W vs 6W_all</a:t>
            </a:r>
            <a:endParaRPr lang="ko-KR" altLang="en-US" sz="12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463264" y="1125559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C</a:t>
            </a:r>
            <a:endParaRPr lang="ko-KR" altLang="en-US" sz="1400" b="1" dirty="0"/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240" y="5797726"/>
            <a:ext cx="8891149" cy="3302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570838" y="5651962"/>
            <a:ext cx="1501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) 15W vs 6W_down</a:t>
            </a:r>
            <a:endParaRPr lang="ko-KR" altLang="en-US" sz="1200" b="1" dirty="0"/>
          </a:p>
        </p:txBody>
      </p:sp>
      <p:pic>
        <p:nvPicPr>
          <p:cNvPr id="8" name="그림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9775" y="9809303"/>
            <a:ext cx="8789151" cy="2627079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8028793" y="10047130"/>
            <a:ext cx="1285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20W vs 6W_all</a:t>
            </a:r>
            <a:endParaRPr lang="ko-KR" altLang="en-US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499023" y="9614824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</a:t>
            </a:r>
            <a:endParaRPr lang="ko-KR" altLang="en-US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281001" y="274651"/>
            <a:ext cx="7936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6. GOCC analyses of the reproductively-aged mouse ovary. </a:t>
            </a:r>
            <a:endParaRPr lang="ko-KR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85700657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1001" y="274651"/>
            <a:ext cx="7936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7. KEGG analyses of the reproductively-aged mouse ovary. </a:t>
            </a:r>
            <a:endParaRPr lang="ko-KR" altLang="en-US" sz="18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</a:t>
            </a:r>
            <a:endParaRPr lang="ko-KR" altLang="en-US" sz="1400" b="1" dirty="0"/>
          </a:p>
        </p:txBody>
      </p:sp>
      <p:grpSp>
        <p:nvGrpSpPr>
          <p:cNvPr id="16" name="그룹 15"/>
          <p:cNvGrpSpPr/>
          <p:nvPr/>
        </p:nvGrpSpPr>
        <p:grpSpPr>
          <a:xfrm>
            <a:off x="896681" y="4916792"/>
            <a:ext cx="8757535" cy="3568657"/>
            <a:chOff x="896681" y="4597807"/>
            <a:chExt cx="8757535" cy="3568657"/>
          </a:xfrm>
        </p:grpSpPr>
        <p:pic>
          <p:nvPicPr>
            <p:cNvPr id="14" name="그림 1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6681" y="4597807"/>
              <a:ext cx="8757535" cy="3568657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7765333" y="4769071"/>
              <a:ext cx="14672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b) 6W vs 2W_up</a:t>
              </a:r>
              <a:endParaRPr lang="ko-KR" altLang="en-US" sz="1200" b="1" dirty="0"/>
            </a:p>
          </p:txBody>
        </p:sp>
      </p:grpSp>
      <p:grpSp>
        <p:nvGrpSpPr>
          <p:cNvPr id="17" name="그룹 16"/>
          <p:cNvGrpSpPr/>
          <p:nvPr/>
        </p:nvGrpSpPr>
        <p:grpSpPr>
          <a:xfrm>
            <a:off x="893137" y="1156870"/>
            <a:ext cx="8748000" cy="3457660"/>
            <a:chOff x="893137" y="1156870"/>
            <a:chExt cx="8748000" cy="3374238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3137" y="1156870"/>
              <a:ext cx="8748000" cy="3374238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7719231" y="1361211"/>
              <a:ext cx="1501955" cy="2703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a) 6W vs 2W_all</a:t>
              </a:r>
              <a:endParaRPr lang="ko-KR" altLang="en-US" sz="1200" b="1" dirty="0"/>
            </a:p>
          </p:txBody>
        </p:sp>
      </p:grpSp>
      <p:grpSp>
        <p:nvGrpSpPr>
          <p:cNvPr id="15" name="그룹 14"/>
          <p:cNvGrpSpPr/>
          <p:nvPr/>
        </p:nvGrpSpPr>
        <p:grpSpPr>
          <a:xfrm>
            <a:off x="281001" y="9020534"/>
            <a:ext cx="9373215" cy="3132481"/>
            <a:chOff x="895583" y="8191193"/>
            <a:chExt cx="8758633" cy="3132481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5583" y="8191193"/>
              <a:ext cx="8758633" cy="3132481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7779500" y="8345159"/>
              <a:ext cx="14672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c) 6W vs 2W_down</a:t>
              </a:r>
              <a:endParaRPr lang="ko-KR" alt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63200552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그림 1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2999" y="4953001"/>
            <a:ext cx="8496000" cy="3331066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B</a:t>
            </a:r>
            <a:endParaRPr lang="ko-KR" alt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7765333" y="5124152"/>
            <a:ext cx="1467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) 15W vs 2W_up</a:t>
            </a:r>
            <a:endParaRPr lang="ko-KR" altLang="en-US" sz="1200" b="1" dirty="0"/>
          </a:p>
        </p:txBody>
      </p:sp>
      <p:grpSp>
        <p:nvGrpSpPr>
          <p:cNvPr id="7" name="그룹 6"/>
          <p:cNvGrpSpPr/>
          <p:nvPr/>
        </p:nvGrpSpPr>
        <p:grpSpPr>
          <a:xfrm>
            <a:off x="834379" y="1168066"/>
            <a:ext cx="8750445" cy="3524453"/>
            <a:chOff x="882505" y="1168067"/>
            <a:chExt cx="8750445" cy="3302000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2505" y="1168067"/>
              <a:ext cx="8750445" cy="330200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7719231" y="1335267"/>
              <a:ext cx="1501955" cy="2595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a) 15W vs 2W_all</a:t>
              </a:r>
              <a:endParaRPr lang="ko-KR" altLang="en-US" sz="1200" b="1" dirty="0"/>
            </a:p>
          </p:txBody>
        </p:sp>
      </p:grpSp>
      <p:grpSp>
        <p:nvGrpSpPr>
          <p:cNvPr id="20" name="그룹 19"/>
          <p:cNvGrpSpPr/>
          <p:nvPr/>
        </p:nvGrpSpPr>
        <p:grpSpPr>
          <a:xfrm>
            <a:off x="745958" y="8869072"/>
            <a:ext cx="8886992" cy="3078277"/>
            <a:chOff x="745958" y="8869072"/>
            <a:chExt cx="8886992" cy="3078277"/>
          </a:xfrm>
        </p:grpSpPr>
        <p:pic>
          <p:nvPicPr>
            <p:cNvPr id="11" name="그림 10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5958" y="8869072"/>
              <a:ext cx="8886992" cy="3078277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7773351" y="9018365"/>
              <a:ext cx="146729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c) 15W vs 2W_down</a:t>
              </a:r>
              <a:endParaRPr lang="ko-KR" altLang="en-US" sz="1200" b="1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281001" y="274651"/>
            <a:ext cx="7936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7. KEGG analyses of the reproductively-aged mouse ovary. </a:t>
            </a:r>
            <a:endParaRPr lang="ko-KR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354791547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C</a:t>
            </a:r>
            <a:endParaRPr lang="ko-KR" altLang="en-US" sz="1400" b="1" dirty="0"/>
          </a:p>
        </p:txBody>
      </p:sp>
      <p:grpSp>
        <p:nvGrpSpPr>
          <p:cNvPr id="11" name="그룹 10"/>
          <p:cNvGrpSpPr/>
          <p:nvPr/>
        </p:nvGrpSpPr>
        <p:grpSpPr>
          <a:xfrm>
            <a:off x="1143000" y="5193639"/>
            <a:ext cx="8482258" cy="3998496"/>
            <a:chOff x="1143000" y="5193639"/>
            <a:chExt cx="8482258" cy="3998496"/>
          </a:xfrm>
        </p:grpSpPr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3000" y="5193639"/>
              <a:ext cx="8482258" cy="3998496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7753301" y="5400888"/>
              <a:ext cx="14672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b) 20W vs 2W_up</a:t>
              </a:r>
              <a:endParaRPr lang="ko-KR" altLang="en-US" sz="1200" b="1" dirty="0"/>
            </a:p>
          </p:txBody>
        </p:sp>
      </p:grpSp>
      <p:grpSp>
        <p:nvGrpSpPr>
          <p:cNvPr id="14" name="그룹 13"/>
          <p:cNvGrpSpPr/>
          <p:nvPr/>
        </p:nvGrpSpPr>
        <p:grpSpPr>
          <a:xfrm>
            <a:off x="721894" y="1177700"/>
            <a:ext cx="8892000" cy="3709391"/>
            <a:chOff x="721894" y="1177700"/>
            <a:chExt cx="8892000" cy="3709391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1894" y="1177700"/>
              <a:ext cx="8892000" cy="3709391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7671105" y="1358562"/>
              <a:ext cx="15019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a) 20W vs 2W_all</a:t>
              </a:r>
              <a:endParaRPr lang="ko-KR" altLang="en-US" sz="1200" b="1" dirty="0"/>
            </a:p>
          </p:txBody>
        </p:sp>
      </p:grpSp>
      <p:grpSp>
        <p:nvGrpSpPr>
          <p:cNvPr id="10" name="그룹 9"/>
          <p:cNvGrpSpPr/>
          <p:nvPr/>
        </p:nvGrpSpPr>
        <p:grpSpPr>
          <a:xfrm>
            <a:off x="1479885" y="9449559"/>
            <a:ext cx="8134010" cy="3051252"/>
            <a:chOff x="1479885" y="9449559"/>
            <a:chExt cx="8134010" cy="3051252"/>
          </a:xfrm>
        </p:grpSpPr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79885" y="9449559"/>
              <a:ext cx="8134010" cy="3051252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7773351" y="9595899"/>
              <a:ext cx="1788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c) 20W vs 2W_down</a:t>
              </a:r>
              <a:endParaRPr lang="ko-KR" altLang="en-US" sz="1200" b="1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281001" y="274651"/>
            <a:ext cx="7936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7. KEGG analyses of the reproductively-aged mouse ovary. </a:t>
            </a:r>
            <a:endParaRPr lang="ko-KR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291361675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</a:t>
            </a:r>
            <a:endParaRPr lang="ko-KR" altLang="en-US" sz="1400" b="1" dirty="0"/>
          </a:p>
        </p:txBody>
      </p:sp>
      <p:grpSp>
        <p:nvGrpSpPr>
          <p:cNvPr id="7" name="그룹 6"/>
          <p:cNvGrpSpPr/>
          <p:nvPr/>
        </p:nvGrpSpPr>
        <p:grpSpPr>
          <a:xfrm>
            <a:off x="1335505" y="4892839"/>
            <a:ext cx="8465891" cy="3462173"/>
            <a:chOff x="1335505" y="4892839"/>
            <a:chExt cx="8465891" cy="3462173"/>
          </a:xfrm>
        </p:grpSpPr>
        <p:pic>
          <p:nvPicPr>
            <p:cNvPr id="13" name="그림 1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35505" y="4892839"/>
              <a:ext cx="8465891" cy="3462173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7765333" y="5076024"/>
              <a:ext cx="14672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b) 15W vs 6W_up</a:t>
              </a:r>
              <a:endParaRPr lang="ko-KR" altLang="en-US" sz="1200" b="1" dirty="0"/>
            </a:p>
          </p:txBody>
        </p:sp>
      </p:grpSp>
      <p:grpSp>
        <p:nvGrpSpPr>
          <p:cNvPr id="9" name="그룹 8"/>
          <p:cNvGrpSpPr/>
          <p:nvPr/>
        </p:nvGrpSpPr>
        <p:grpSpPr>
          <a:xfrm>
            <a:off x="733925" y="1164206"/>
            <a:ext cx="9007311" cy="3359667"/>
            <a:chOff x="733925" y="1164206"/>
            <a:chExt cx="9007311" cy="3359667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3925" y="1164206"/>
              <a:ext cx="9007311" cy="3359667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7671105" y="1346530"/>
              <a:ext cx="15019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a) 15W vs 6W_all</a:t>
              </a:r>
              <a:endParaRPr lang="ko-KR" altLang="en-US" sz="1200" b="1" dirty="0"/>
            </a:p>
          </p:txBody>
        </p:sp>
      </p:grpSp>
      <p:grpSp>
        <p:nvGrpSpPr>
          <p:cNvPr id="5" name="그룹 4"/>
          <p:cNvGrpSpPr/>
          <p:nvPr/>
        </p:nvGrpSpPr>
        <p:grpSpPr>
          <a:xfrm>
            <a:off x="723017" y="9055559"/>
            <a:ext cx="9078379" cy="3302000"/>
            <a:chOff x="723017" y="9055559"/>
            <a:chExt cx="9078379" cy="3302000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3017" y="9055559"/>
              <a:ext cx="9078379" cy="3302000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7773351" y="9222907"/>
              <a:ext cx="1788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c) 15W vs 6W_down</a:t>
              </a:r>
              <a:endParaRPr lang="ko-KR" altLang="en-US" sz="1200" b="1" dirty="0"/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281001" y="274651"/>
            <a:ext cx="7936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7. KEGG analyses of the reproductively-aged mouse ovary. </a:t>
            </a:r>
            <a:endParaRPr lang="ko-KR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19712119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/>
          <p:cNvGrpSpPr/>
          <p:nvPr/>
        </p:nvGrpSpPr>
        <p:grpSpPr>
          <a:xfrm>
            <a:off x="824168" y="1768049"/>
            <a:ext cx="3747831" cy="3756472"/>
            <a:chOff x="1186119" y="1194941"/>
            <a:chExt cx="3600000" cy="3600000"/>
          </a:xfrm>
        </p:grpSpPr>
        <p:pic>
          <p:nvPicPr>
            <p:cNvPr id="10" name="그림 9"/>
            <p:cNvPicPr preferRelativeResize="0">
              <a:picLocks/>
            </p:cNvPicPr>
            <p:nvPr/>
          </p:nvPicPr>
          <p:blipFill rotWithShape="1">
            <a:blip r:embed="rId2"/>
            <a:srcRect l="13719" t="17285" r="12319"/>
            <a:stretch/>
          </p:blipFill>
          <p:spPr>
            <a:xfrm>
              <a:off x="1186119" y="1194941"/>
              <a:ext cx="3600000" cy="3600000"/>
            </a:xfrm>
            <a:prstGeom prst="rect">
              <a:avLst/>
            </a:prstGeom>
          </p:spPr>
        </p:pic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52166" y="1464176"/>
              <a:ext cx="536426" cy="584420"/>
            </a:xfrm>
            <a:prstGeom prst="rect">
              <a:avLst/>
            </a:prstGeom>
          </p:spPr>
        </p:pic>
      </p:grpSp>
      <p:pic>
        <p:nvPicPr>
          <p:cNvPr id="6" name="그림 5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5540904" y="1645355"/>
            <a:ext cx="3815744" cy="375518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81001" y="274651"/>
            <a:ext cx="9075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2. Correlation analyses of expressed genes in the reproductively-aged mouse ovary. </a:t>
            </a:r>
            <a:endParaRPr lang="ko-KR" altLang="en-US" sz="18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563529" y="1126507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</a:t>
            </a:r>
            <a:endParaRPr lang="ko-KR" alt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5362370" y="1119416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B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403936384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E</a:t>
            </a:r>
            <a:endParaRPr lang="ko-KR" altLang="en-US" sz="1400" b="1" dirty="0"/>
          </a:p>
        </p:txBody>
      </p:sp>
      <p:grpSp>
        <p:nvGrpSpPr>
          <p:cNvPr id="20" name="그룹 19"/>
          <p:cNvGrpSpPr/>
          <p:nvPr/>
        </p:nvGrpSpPr>
        <p:grpSpPr>
          <a:xfrm>
            <a:off x="884239" y="5021104"/>
            <a:ext cx="8748711" cy="3906249"/>
            <a:chOff x="884238" y="5021104"/>
            <a:chExt cx="8885403" cy="3906249"/>
          </a:xfrm>
        </p:grpSpPr>
        <p:pic>
          <p:nvPicPr>
            <p:cNvPr id="16" name="그림 15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4238" y="5021104"/>
              <a:ext cx="8885403" cy="3906249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8032764" y="5208369"/>
              <a:ext cx="14291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b) 20W vs 6W_up</a:t>
              </a:r>
              <a:endParaRPr lang="ko-KR" altLang="en-US" sz="1200" b="1" dirty="0"/>
            </a:p>
          </p:txBody>
        </p:sp>
      </p:grpSp>
      <p:grpSp>
        <p:nvGrpSpPr>
          <p:cNvPr id="21" name="그룹 20"/>
          <p:cNvGrpSpPr/>
          <p:nvPr/>
        </p:nvGrpSpPr>
        <p:grpSpPr>
          <a:xfrm>
            <a:off x="882505" y="1173216"/>
            <a:ext cx="8750446" cy="3669033"/>
            <a:chOff x="882504" y="1173216"/>
            <a:chExt cx="8887137" cy="3669033"/>
          </a:xfrm>
        </p:grpSpPr>
        <p:pic>
          <p:nvPicPr>
            <p:cNvPr id="14" name="그림 1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2504" y="1173216"/>
              <a:ext cx="8887137" cy="3669033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7863613" y="1346530"/>
              <a:ext cx="15019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a) 20W vs 6W_all</a:t>
              </a:r>
              <a:endParaRPr lang="ko-KR" altLang="en-US" sz="1200" b="1" dirty="0"/>
            </a:p>
          </p:txBody>
        </p:sp>
      </p:grpSp>
      <p:grpSp>
        <p:nvGrpSpPr>
          <p:cNvPr id="17" name="그룹 16"/>
          <p:cNvGrpSpPr/>
          <p:nvPr/>
        </p:nvGrpSpPr>
        <p:grpSpPr>
          <a:xfrm>
            <a:off x="884239" y="9222904"/>
            <a:ext cx="8748712" cy="3253842"/>
            <a:chOff x="884238" y="9222906"/>
            <a:chExt cx="8885403" cy="2951648"/>
          </a:xfrm>
        </p:grpSpPr>
        <p:pic>
          <p:nvPicPr>
            <p:cNvPr id="15" name="그림 1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4238" y="9222906"/>
              <a:ext cx="8885403" cy="2951648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7895550" y="9367291"/>
              <a:ext cx="1645088" cy="2512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c) 20W vs 6W_down</a:t>
              </a:r>
              <a:endParaRPr lang="ko-KR" altLang="en-US" sz="1200" b="1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281001" y="274651"/>
            <a:ext cx="7936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7. KEGG analyses of the reproductively-aged mouse ovary. </a:t>
            </a:r>
            <a:endParaRPr lang="ko-KR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79497232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505" y="8900756"/>
            <a:ext cx="8851042" cy="3624118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505" y="5037223"/>
            <a:ext cx="8851042" cy="3685671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505" y="1173692"/>
            <a:ext cx="8851042" cy="362690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F</a:t>
            </a:r>
            <a:endParaRPr lang="ko-KR" alt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7851986" y="5220401"/>
            <a:ext cx="14447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) 20W vs 15W_up</a:t>
            </a:r>
            <a:endParaRPr lang="ko-KR" altLang="en-US" sz="12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7816400" y="1358562"/>
            <a:ext cx="14788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a) 20W vs 15W_all</a:t>
            </a:r>
            <a:endParaRPr lang="ko-KR" alt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7821951" y="9081287"/>
            <a:ext cx="1677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) 20W vs 15W_down</a:t>
            </a:r>
            <a:endParaRPr lang="ko-KR" altLang="en-US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81001" y="274651"/>
            <a:ext cx="7936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7. KEGG analyses of the reproductively-aged mouse ovary. </a:t>
            </a:r>
            <a:endParaRPr lang="ko-KR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377146788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81001" y="274651"/>
            <a:ext cx="9075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8. Predictive protein interaction of up- and down-regulated transcripts in the  reproductively-aged mouse ovary. </a:t>
            </a:r>
            <a:endParaRPr lang="ko-KR" altLang="en-US" sz="18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27157" y="1032708"/>
            <a:ext cx="428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)</a:t>
            </a:r>
            <a:endParaRPr lang="ko-KR" altLang="en-US" sz="1400" b="1" dirty="0"/>
          </a:p>
        </p:txBody>
      </p:sp>
      <p:grpSp>
        <p:nvGrpSpPr>
          <p:cNvPr id="24" name="그룹 23"/>
          <p:cNvGrpSpPr/>
          <p:nvPr/>
        </p:nvGrpSpPr>
        <p:grpSpPr>
          <a:xfrm>
            <a:off x="374103" y="1625693"/>
            <a:ext cx="3193312" cy="2949431"/>
            <a:chOff x="4983125" y="1170225"/>
            <a:chExt cx="3193312" cy="2949431"/>
          </a:xfrm>
        </p:grpSpPr>
        <p:pic>
          <p:nvPicPr>
            <p:cNvPr id="14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934" r="29777"/>
            <a:stretch/>
          </p:blipFill>
          <p:spPr>
            <a:xfrm>
              <a:off x="4983125" y="1170225"/>
              <a:ext cx="3193312" cy="2949431"/>
            </a:xfrm>
            <a:prstGeom prst="rect">
              <a:avLst/>
            </a:prstGeom>
          </p:spPr>
        </p:pic>
        <p:sp>
          <p:nvSpPr>
            <p:cNvPr id="2" name="직사각형 1"/>
            <p:cNvSpPr/>
            <p:nvPr/>
          </p:nvSpPr>
          <p:spPr>
            <a:xfrm>
              <a:off x="5399941" y="3531921"/>
              <a:ext cx="631146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400" b="1" dirty="0" err="1">
                  <a:solidFill>
                    <a:srgbClr val="00B0F0"/>
                  </a:solidFill>
                </a:rPr>
                <a:t>Bhmt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23" name="그룹 22"/>
          <p:cNvGrpSpPr/>
          <p:nvPr/>
        </p:nvGrpSpPr>
        <p:grpSpPr>
          <a:xfrm>
            <a:off x="3081401" y="1590056"/>
            <a:ext cx="3413051" cy="2997916"/>
            <a:chOff x="6492949" y="2964914"/>
            <a:chExt cx="3413051" cy="2997916"/>
          </a:xfrm>
        </p:grpSpPr>
        <p:pic>
          <p:nvPicPr>
            <p:cNvPr id="17" name="내용 개체 틀 7" descr="위성이(가) 표시된 사진&#10;&#10;자동 생성된 설명">
              <a:extLst>
                <a:ext uri="{FF2B5EF4-FFF2-40B4-BE49-F238E27FC236}">
                  <a16:creationId xmlns:a16="http://schemas.microsoft.com/office/drawing/2014/main" id="{633DED43-70BE-4B32-9AE2-F04EC1EF95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99" r="28025"/>
            <a:stretch/>
          </p:blipFill>
          <p:spPr>
            <a:xfrm>
              <a:off x="6492949" y="2964914"/>
              <a:ext cx="3413051" cy="2997916"/>
            </a:xfrm>
            <a:prstGeom prst="rect">
              <a:avLst/>
            </a:prstGeom>
          </p:spPr>
        </p:pic>
        <p:sp>
          <p:nvSpPr>
            <p:cNvPr id="3" name="직사각형 2"/>
            <p:cNvSpPr/>
            <p:nvPr/>
          </p:nvSpPr>
          <p:spPr>
            <a:xfrm>
              <a:off x="8366424" y="3318715"/>
              <a:ext cx="116908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Spp1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28" name="그룹 27"/>
          <p:cNvGrpSpPr/>
          <p:nvPr/>
        </p:nvGrpSpPr>
        <p:grpSpPr>
          <a:xfrm>
            <a:off x="524859" y="4587972"/>
            <a:ext cx="4047183" cy="3937220"/>
            <a:chOff x="705569" y="5787797"/>
            <a:chExt cx="4047183" cy="3937220"/>
          </a:xfrm>
        </p:grpSpPr>
        <p:pic>
          <p:nvPicPr>
            <p:cNvPr id="18" name="내용 개체 틀 7">
              <a:extLst>
                <a:ext uri="{FF2B5EF4-FFF2-40B4-BE49-F238E27FC236}">
                  <a16:creationId xmlns:a16="http://schemas.microsoft.com/office/drawing/2014/main" id="{633DED43-70BE-4B32-9AE2-F04EC1EF95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68" r="19964"/>
            <a:stretch/>
          </p:blipFill>
          <p:spPr>
            <a:xfrm>
              <a:off x="705569" y="5787797"/>
              <a:ext cx="4047183" cy="3937220"/>
            </a:xfrm>
            <a:prstGeom prst="rect">
              <a:avLst/>
            </a:prstGeom>
          </p:spPr>
        </p:pic>
        <p:sp>
          <p:nvSpPr>
            <p:cNvPr id="4" name="직사각형 3"/>
            <p:cNvSpPr/>
            <p:nvPr/>
          </p:nvSpPr>
          <p:spPr>
            <a:xfrm>
              <a:off x="3115769" y="7058204"/>
              <a:ext cx="632355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Klk1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27" name="그룹 26"/>
          <p:cNvGrpSpPr/>
          <p:nvPr/>
        </p:nvGrpSpPr>
        <p:grpSpPr>
          <a:xfrm>
            <a:off x="6494452" y="1717600"/>
            <a:ext cx="3067061" cy="2415428"/>
            <a:chOff x="4614527" y="4967776"/>
            <a:chExt cx="3067061" cy="2415428"/>
          </a:xfrm>
        </p:grpSpPr>
        <p:pic>
          <p:nvPicPr>
            <p:cNvPr id="19" name="내용 개체 틀 7">
              <a:extLst>
                <a:ext uri="{FF2B5EF4-FFF2-40B4-BE49-F238E27FC236}">
                  <a16:creationId xmlns:a16="http://schemas.microsoft.com/office/drawing/2014/main" id="{633DED43-70BE-4B32-9AE2-F04EC1EF95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055" r="31298"/>
            <a:stretch/>
          </p:blipFill>
          <p:spPr>
            <a:xfrm>
              <a:off x="4614527" y="4967776"/>
              <a:ext cx="3067061" cy="2415428"/>
            </a:xfrm>
            <a:prstGeom prst="rect">
              <a:avLst/>
            </a:prstGeom>
          </p:spPr>
        </p:pic>
        <p:sp>
          <p:nvSpPr>
            <p:cNvPr id="5" name="직사각형 4"/>
            <p:cNvSpPr/>
            <p:nvPr/>
          </p:nvSpPr>
          <p:spPr>
            <a:xfrm>
              <a:off x="6014749" y="5050643"/>
              <a:ext cx="84029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Serpina5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25" name="그룹 24"/>
          <p:cNvGrpSpPr/>
          <p:nvPr/>
        </p:nvGrpSpPr>
        <p:grpSpPr>
          <a:xfrm>
            <a:off x="6494452" y="6300000"/>
            <a:ext cx="3096384" cy="2811916"/>
            <a:chOff x="7102552" y="5877230"/>
            <a:chExt cx="2796362" cy="2416520"/>
          </a:xfrm>
        </p:grpSpPr>
        <p:pic>
          <p:nvPicPr>
            <p:cNvPr id="20" name="내용 개체 틀 7">
              <a:extLst>
                <a:ext uri="{FF2B5EF4-FFF2-40B4-BE49-F238E27FC236}">
                  <a16:creationId xmlns:a16="http://schemas.microsoft.com/office/drawing/2014/main" id="{633DED43-70BE-4B32-9AE2-F04EC1EF95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46" r="33621"/>
            <a:stretch/>
          </p:blipFill>
          <p:spPr>
            <a:xfrm>
              <a:off x="7102552" y="5877230"/>
              <a:ext cx="2796362" cy="2416520"/>
            </a:xfrm>
            <a:prstGeom prst="rect">
              <a:avLst/>
            </a:prstGeom>
          </p:spPr>
        </p:pic>
        <p:sp>
          <p:nvSpPr>
            <p:cNvPr id="6" name="직사각형 5"/>
            <p:cNvSpPr/>
            <p:nvPr/>
          </p:nvSpPr>
          <p:spPr>
            <a:xfrm>
              <a:off x="9177220" y="7656065"/>
              <a:ext cx="521455" cy="2644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Sfrp4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9" name="그룹 8"/>
          <p:cNvGrpSpPr/>
          <p:nvPr/>
        </p:nvGrpSpPr>
        <p:grpSpPr>
          <a:xfrm>
            <a:off x="4381408" y="4285228"/>
            <a:ext cx="4260586" cy="3300660"/>
            <a:chOff x="4381408" y="4285228"/>
            <a:chExt cx="4260586" cy="3300660"/>
          </a:xfrm>
        </p:grpSpPr>
        <p:sp>
          <p:nvSpPr>
            <p:cNvPr id="21" name="직사각형 20"/>
            <p:cNvSpPr/>
            <p:nvPr/>
          </p:nvSpPr>
          <p:spPr>
            <a:xfrm>
              <a:off x="7057917" y="4715293"/>
              <a:ext cx="573092" cy="31537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Plin4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  <p:pic>
          <p:nvPicPr>
            <p:cNvPr id="22" name="내용 개체 틀 7">
              <a:extLst>
                <a:ext uri="{FF2B5EF4-FFF2-40B4-BE49-F238E27FC236}">
                  <a16:creationId xmlns:a16="http://schemas.microsoft.com/office/drawing/2014/main" id="{633DED43-70BE-4B32-9AE2-F04EC1EF95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925" r="23595"/>
            <a:stretch/>
          </p:blipFill>
          <p:spPr>
            <a:xfrm>
              <a:off x="4381408" y="4285228"/>
              <a:ext cx="4260586" cy="3300660"/>
            </a:xfrm>
            <a:prstGeom prst="rect">
              <a:avLst/>
            </a:prstGeom>
          </p:spPr>
        </p:pic>
      </p:grpSp>
      <p:grpSp>
        <p:nvGrpSpPr>
          <p:cNvPr id="33" name="그룹 32"/>
          <p:cNvGrpSpPr/>
          <p:nvPr/>
        </p:nvGrpSpPr>
        <p:grpSpPr>
          <a:xfrm>
            <a:off x="3228866" y="7742733"/>
            <a:ext cx="4134460" cy="3383955"/>
            <a:chOff x="5859736" y="9424400"/>
            <a:chExt cx="3829051" cy="2949431"/>
          </a:xfrm>
        </p:grpSpPr>
        <p:pic>
          <p:nvPicPr>
            <p:cNvPr id="30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03" r="12398"/>
            <a:stretch/>
          </p:blipFill>
          <p:spPr>
            <a:xfrm>
              <a:off x="5859736" y="9424400"/>
              <a:ext cx="3829051" cy="2949431"/>
            </a:xfrm>
            <a:prstGeom prst="rect">
              <a:avLst/>
            </a:prstGeom>
          </p:spPr>
        </p:pic>
        <p:sp>
          <p:nvSpPr>
            <p:cNvPr id="32" name="직사각형 31"/>
            <p:cNvSpPr/>
            <p:nvPr/>
          </p:nvSpPr>
          <p:spPr>
            <a:xfrm>
              <a:off x="7943418" y="10899115"/>
              <a:ext cx="1314159" cy="26825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GM1987(Ccl21a)</a:t>
              </a:r>
              <a:endParaRPr lang="ko-KR" altLang="en-US" sz="1100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35" name="그룹 34"/>
          <p:cNvGrpSpPr/>
          <p:nvPr/>
        </p:nvGrpSpPr>
        <p:grpSpPr>
          <a:xfrm>
            <a:off x="524859" y="8682037"/>
            <a:ext cx="3314700" cy="2949431"/>
            <a:chOff x="2147072" y="9517823"/>
            <a:chExt cx="3314700" cy="2949431"/>
          </a:xfrm>
        </p:grpSpPr>
        <p:pic>
          <p:nvPicPr>
            <p:cNvPr id="29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848" r="20905"/>
            <a:stretch/>
          </p:blipFill>
          <p:spPr>
            <a:xfrm>
              <a:off x="2147072" y="9517823"/>
              <a:ext cx="3314700" cy="2949431"/>
            </a:xfrm>
            <a:prstGeom prst="rect">
              <a:avLst/>
            </a:prstGeom>
          </p:spPr>
        </p:pic>
        <p:sp>
          <p:nvSpPr>
            <p:cNvPr id="34" name="직사각형 33"/>
            <p:cNvSpPr/>
            <p:nvPr/>
          </p:nvSpPr>
          <p:spPr>
            <a:xfrm>
              <a:off x="2376665" y="10741822"/>
              <a:ext cx="65274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Wisp2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744398" y="1033961"/>
            <a:ext cx="29751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Up-regulation in 6W vs 2W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48013169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그룹 7"/>
          <p:cNvGrpSpPr/>
          <p:nvPr/>
        </p:nvGrpSpPr>
        <p:grpSpPr>
          <a:xfrm>
            <a:off x="1039249" y="1511085"/>
            <a:ext cx="3421948" cy="2924479"/>
            <a:chOff x="894871" y="1358421"/>
            <a:chExt cx="3198664" cy="2672016"/>
          </a:xfrm>
        </p:grpSpPr>
        <p:pic>
          <p:nvPicPr>
            <p:cNvPr id="6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362" r="31260"/>
            <a:stretch/>
          </p:blipFill>
          <p:spPr>
            <a:xfrm>
              <a:off x="894871" y="1358421"/>
              <a:ext cx="3198664" cy="2672016"/>
            </a:xfrm>
            <a:prstGeom prst="rect">
              <a:avLst/>
            </a:prstGeom>
          </p:spPr>
        </p:pic>
        <p:sp>
          <p:nvSpPr>
            <p:cNvPr id="7" name="직사각형 6"/>
            <p:cNvSpPr/>
            <p:nvPr/>
          </p:nvSpPr>
          <p:spPr>
            <a:xfrm>
              <a:off x="1195401" y="1457241"/>
              <a:ext cx="867877" cy="2812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FF9933"/>
                  </a:solidFill>
                </a:rPr>
                <a:t>BC100530</a:t>
              </a:r>
              <a:endParaRPr lang="ko-KR" altLang="en-US" sz="1400" b="1" dirty="0">
                <a:solidFill>
                  <a:srgbClr val="FF9933"/>
                </a:solidFill>
              </a:endParaRPr>
            </a:p>
          </p:txBody>
        </p:sp>
      </p:grpSp>
      <p:grpSp>
        <p:nvGrpSpPr>
          <p:cNvPr id="11" name="그룹 10"/>
          <p:cNvGrpSpPr/>
          <p:nvPr/>
        </p:nvGrpSpPr>
        <p:grpSpPr>
          <a:xfrm>
            <a:off x="4922144" y="1488440"/>
            <a:ext cx="4303368" cy="4537186"/>
            <a:chOff x="4394065" y="1358421"/>
            <a:chExt cx="4303368" cy="4537186"/>
          </a:xfrm>
        </p:grpSpPr>
        <p:pic>
          <p:nvPicPr>
            <p:cNvPr id="9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869" r="21114"/>
            <a:stretch/>
          </p:blipFill>
          <p:spPr>
            <a:xfrm>
              <a:off x="4394065" y="1358421"/>
              <a:ext cx="4303368" cy="4537186"/>
            </a:xfrm>
            <a:prstGeom prst="rect">
              <a:avLst/>
            </a:prstGeom>
          </p:spPr>
        </p:pic>
        <p:sp>
          <p:nvSpPr>
            <p:cNvPr id="10" name="직사각형 9"/>
            <p:cNvSpPr/>
            <p:nvPr/>
          </p:nvSpPr>
          <p:spPr>
            <a:xfrm>
              <a:off x="5063917" y="4030437"/>
              <a:ext cx="101540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FF9933"/>
                  </a:solidFill>
                </a:rPr>
                <a:t>Tmem254b</a:t>
              </a:r>
              <a:endParaRPr lang="ko-KR" altLang="en-US" sz="1400" b="1" dirty="0">
                <a:solidFill>
                  <a:srgbClr val="FF9933"/>
                </a:solidFill>
              </a:endParaRPr>
            </a:p>
          </p:txBody>
        </p:sp>
      </p:grpSp>
      <p:grpSp>
        <p:nvGrpSpPr>
          <p:cNvPr id="14" name="그룹 13"/>
          <p:cNvGrpSpPr/>
          <p:nvPr/>
        </p:nvGrpSpPr>
        <p:grpSpPr>
          <a:xfrm>
            <a:off x="720725" y="3995037"/>
            <a:ext cx="4946424" cy="3567502"/>
            <a:chOff x="894871" y="3746352"/>
            <a:chExt cx="3774559" cy="2949431"/>
          </a:xfrm>
        </p:grpSpPr>
        <p:pic>
          <p:nvPicPr>
            <p:cNvPr id="12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83" r="20051"/>
            <a:stretch/>
          </p:blipFill>
          <p:spPr>
            <a:xfrm>
              <a:off x="894871" y="3746352"/>
              <a:ext cx="3774559" cy="2949431"/>
            </a:xfrm>
            <a:prstGeom prst="rect">
              <a:avLst/>
            </a:prstGeom>
          </p:spPr>
        </p:pic>
        <p:sp>
          <p:nvSpPr>
            <p:cNvPr id="13" name="직사각형 12"/>
            <p:cNvSpPr/>
            <p:nvPr/>
          </p:nvSpPr>
          <p:spPr>
            <a:xfrm>
              <a:off x="2300928" y="4168936"/>
              <a:ext cx="403912" cy="2544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 err="1">
                  <a:solidFill>
                    <a:srgbClr val="FF9933"/>
                  </a:solidFill>
                </a:rPr>
                <a:t>Figla</a:t>
              </a:r>
              <a:endParaRPr lang="ko-KR" altLang="en-US" sz="1400" b="1" dirty="0">
                <a:solidFill>
                  <a:srgbClr val="FF9933"/>
                </a:solidFill>
              </a:endParaRPr>
            </a:p>
          </p:txBody>
        </p:sp>
      </p:grpSp>
      <p:grpSp>
        <p:nvGrpSpPr>
          <p:cNvPr id="17" name="그룹 16"/>
          <p:cNvGrpSpPr/>
          <p:nvPr/>
        </p:nvGrpSpPr>
        <p:grpSpPr>
          <a:xfrm>
            <a:off x="6272474" y="5148778"/>
            <a:ext cx="3558363" cy="2801935"/>
            <a:chOff x="6760993" y="4619591"/>
            <a:chExt cx="3145007" cy="2524812"/>
          </a:xfrm>
        </p:grpSpPr>
        <p:pic>
          <p:nvPicPr>
            <p:cNvPr id="15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817" r="30411"/>
            <a:stretch/>
          </p:blipFill>
          <p:spPr>
            <a:xfrm>
              <a:off x="6760993" y="4619591"/>
              <a:ext cx="3145007" cy="2524812"/>
            </a:xfrm>
            <a:prstGeom prst="rect">
              <a:avLst/>
            </a:prstGeom>
          </p:spPr>
        </p:pic>
        <p:sp>
          <p:nvSpPr>
            <p:cNvPr id="16" name="직사각형 15"/>
            <p:cNvSpPr/>
            <p:nvPr/>
          </p:nvSpPr>
          <p:spPr>
            <a:xfrm>
              <a:off x="7002577" y="6671247"/>
              <a:ext cx="499277" cy="2773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FF9933"/>
                  </a:solidFill>
                </a:rPr>
                <a:t>Stfa1</a:t>
              </a:r>
              <a:endParaRPr lang="ko-KR" altLang="en-US" sz="1400" b="1" dirty="0">
                <a:solidFill>
                  <a:srgbClr val="FF9933"/>
                </a:solidFill>
              </a:endParaRPr>
            </a:p>
          </p:txBody>
        </p:sp>
      </p:grpSp>
      <p:grpSp>
        <p:nvGrpSpPr>
          <p:cNvPr id="5" name="그룹 4"/>
          <p:cNvGrpSpPr/>
          <p:nvPr/>
        </p:nvGrpSpPr>
        <p:grpSpPr>
          <a:xfrm>
            <a:off x="1060468" y="7461586"/>
            <a:ext cx="3794078" cy="3776998"/>
            <a:chOff x="559558" y="8507745"/>
            <a:chExt cx="3794078" cy="3776998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6"/>
            <a:srcRect l="9963"/>
            <a:stretch/>
          </p:blipFill>
          <p:spPr>
            <a:xfrm>
              <a:off x="559558" y="8507745"/>
              <a:ext cx="3794078" cy="3776998"/>
            </a:xfrm>
            <a:prstGeom prst="rect">
              <a:avLst/>
            </a:prstGeom>
          </p:spPr>
        </p:pic>
        <p:sp>
          <p:nvSpPr>
            <p:cNvPr id="21" name="직사각형 20"/>
            <p:cNvSpPr/>
            <p:nvPr/>
          </p:nvSpPr>
          <p:spPr>
            <a:xfrm>
              <a:off x="714427" y="10482706"/>
              <a:ext cx="72327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FF9933"/>
                  </a:solidFill>
                </a:rPr>
                <a:t>S100a8</a:t>
              </a:r>
              <a:endParaRPr lang="ko-KR" altLang="en-US" sz="1400" b="1" dirty="0">
                <a:solidFill>
                  <a:srgbClr val="FF9933"/>
                </a:solidFill>
              </a:endParaRPr>
            </a:p>
          </p:txBody>
        </p:sp>
      </p:grpSp>
      <p:grpSp>
        <p:nvGrpSpPr>
          <p:cNvPr id="20" name="그룹 19"/>
          <p:cNvGrpSpPr/>
          <p:nvPr/>
        </p:nvGrpSpPr>
        <p:grpSpPr>
          <a:xfrm>
            <a:off x="3765377" y="7727958"/>
            <a:ext cx="4796590" cy="4220029"/>
            <a:chOff x="2878624" y="5822274"/>
            <a:chExt cx="4796590" cy="4220029"/>
          </a:xfrm>
        </p:grpSpPr>
        <p:pic>
          <p:nvPicPr>
            <p:cNvPr id="18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796" r="19160"/>
            <a:stretch/>
          </p:blipFill>
          <p:spPr>
            <a:xfrm>
              <a:off x="2878624" y="5822274"/>
              <a:ext cx="4796590" cy="4220029"/>
            </a:xfrm>
            <a:prstGeom prst="rect">
              <a:avLst/>
            </a:prstGeom>
          </p:spPr>
        </p:pic>
        <p:sp>
          <p:nvSpPr>
            <p:cNvPr id="19" name="직사각형 18"/>
            <p:cNvSpPr/>
            <p:nvPr/>
          </p:nvSpPr>
          <p:spPr>
            <a:xfrm>
              <a:off x="6333586" y="9262045"/>
              <a:ext cx="72327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FF9933"/>
                  </a:solidFill>
                </a:rPr>
                <a:t>S100a9</a:t>
              </a:r>
              <a:endParaRPr lang="ko-KR" altLang="en-US" sz="1400" b="1" dirty="0">
                <a:solidFill>
                  <a:srgbClr val="FF9933"/>
                </a:solidFill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281001" y="274651"/>
            <a:ext cx="9075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8. Predictive protein interaction of up- and down-regulated transcripts in the reproductively-aged mouse ovary. </a:t>
            </a:r>
            <a:endParaRPr lang="ko-KR" altLang="en-US" sz="18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427157" y="1032708"/>
            <a:ext cx="428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B)</a:t>
            </a:r>
            <a:endParaRPr lang="ko-KR" altLang="en-US" sz="14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744398" y="1033961"/>
            <a:ext cx="29751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own-regulation in 6W vs 2W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14078322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그림 15"/>
          <p:cNvPicPr>
            <a:picLocks noChangeAspect="1"/>
          </p:cNvPicPr>
          <p:nvPr/>
        </p:nvPicPr>
        <p:blipFill rotWithShape="1">
          <a:blip r:embed="rId2"/>
          <a:srcRect l="4783" r="1689"/>
          <a:stretch/>
        </p:blipFill>
        <p:spPr>
          <a:xfrm>
            <a:off x="2729363" y="3696944"/>
            <a:ext cx="4694830" cy="3352800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5675062" y="4139877"/>
            <a:ext cx="5581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solidFill>
                  <a:srgbClr val="00B0F0"/>
                </a:solidFill>
              </a:rPr>
              <a:t>Plin4</a:t>
            </a:r>
            <a:endParaRPr lang="ko-KR" altLang="en-US" sz="1400" b="1" dirty="0">
              <a:solidFill>
                <a:srgbClr val="00B0F0"/>
              </a:solidFill>
            </a:endParaRPr>
          </a:p>
        </p:txBody>
      </p:sp>
      <p:grpSp>
        <p:nvGrpSpPr>
          <p:cNvPr id="51" name="그룹 50"/>
          <p:cNvGrpSpPr/>
          <p:nvPr/>
        </p:nvGrpSpPr>
        <p:grpSpPr>
          <a:xfrm>
            <a:off x="839561" y="8575884"/>
            <a:ext cx="3262398" cy="3314700"/>
            <a:chOff x="2359155" y="9369210"/>
            <a:chExt cx="2990850" cy="3314700"/>
          </a:xfrm>
        </p:grpSpPr>
        <p:pic>
          <p:nvPicPr>
            <p:cNvPr id="46" name="그림 4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59155" y="9369210"/>
              <a:ext cx="2990850" cy="3314700"/>
            </a:xfrm>
            <a:prstGeom prst="rect">
              <a:avLst/>
            </a:prstGeom>
          </p:spPr>
        </p:pic>
        <p:sp>
          <p:nvSpPr>
            <p:cNvPr id="34" name="직사각형 33"/>
            <p:cNvSpPr/>
            <p:nvPr/>
          </p:nvSpPr>
          <p:spPr>
            <a:xfrm>
              <a:off x="4421893" y="9639623"/>
              <a:ext cx="53957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 err="1">
                  <a:solidFill>
                    <a:srgbClr val="00B0F0"/>
                  </a:solidFill>
                </a:rPr>
                <a:t>Bhmt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10" name="그룹 9"/>
          <p:cNvGrpSpPr/>
          <p:nvPr/>
        </p:nvGrpSpPr>
        <p:grpSpPr>
          <a:xfrm>
            <a:off x="-72386" y="5129099"/>
            <a:ext cx="4080681" cy="3501486"/>
            <a:chOff x="4965863" y="1339391"/>
            <a:chExt cx="3315988" cy="2781138"/>
          </a:xfrm>
        </p:grpSpPr>
        <p:pic>
          <p:nvPicPr>
            <p:cNvPr id="38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719" r="28722"/>
            <a:stretch/>
          </p:blipFill>
          <p:spPr>
            <a:xfrm>
              <a:off x="4965863" y="1339391"/>
              <a:ext cx="3315988" cy="2781138"/>
            </a:xfrm>
            <a:prstGeom prst="rect">
              <a:avLst/>
            </a:prstGeom>
          </p:spPr>
        </p:pic>
        <p:sp>
          <p:nvSpPr>
            <p:cNvPr id="8" name="직사각형 7"/>
            <p:cNvSpPr/>
            <p:nvPr/>
          </p:nvSpPr>
          <p:spPr>
            <a:xfrm>
              <a:off x="5947948" y="3516563"/>
              <a:ext cx="633173" cy="2444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Wnt10b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sp>
        <p:nvSpPr>
          <p:cNvPr id="3" name="직사각형 2"/>
          <p:cNvSpPr/>
          <p:nvPr/>
        </p:nvSpPr>
        <p:spPr>
          <a:xfrm>
            <a:off x="5750468" y="2614635"/>
            <a:ext cx="13612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solidFill>
                  <a:srgbClr val="00B0F0"/>
                </a:solidFill>
              </a:rPr>
              <a:t>H2-T9(Gm7030)</a:t>
            </a:r>
            <a:endParaRPr lang="ko-KR" altLang="en-US" sz="1400" b="1" dirty="0">
              <a:solidFill>
                <a:srgbClr val="00B0F0"/>
              </a:solidFill>
            </a:endParaRPr>
          </a:p>
        </p:txBody>
      </p:sp>
      <p:pic>
        <p:nvPicPr>
          <p:cNvPr id="39" name="내용 개체 틀 4">
            <a:extLst>
              <a:ext uri="{FF2B5EF4-FFF2-40B4-BE49-F238E27FC236}">
                <a16:creationId xmlns:a16="http://schemas.microsoft.com/office/drawing/2014/main" id="{098E4CEF-EE37-4285-9510-98FAA694AA6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02" r="26504"/>
          <a:stretch/>
        </p:blipFill>
        <p:spPr>
          <a:xfrm>
            <a:off x="5759507" y="1096247"/>
            <a:ext cx="4011054" cy="3474886"/>
          </a:xfrm>
          <a:prstGeom prst="rect">
            <a:avLst/>
          </a:prstGeom>
        </p:spPr>
      </p:pic>
      <p:grpSp>
        <p:nvGrpSpPr>
          <p:cNvPr id="44" name="그룹 43"/>
          <p:cNvGrpSpPr/>
          <p:nvPr/>
        </p:nvGrpSpPr>
        <p:grpSpPr>
          <a:xfrm>
            <a:off x="-78472" y="1337047"/>
            <a:ext cx="4372667" cy="3999566"/>
            <a:chOff x="3056394" y="6009787"/>
            <a:chExt cx="3785345" cy="3531256"/>
          </a:xfrm>
        </p:grpSpPr>
        <p:pic>
          <p:nvPicPr>
            <p:cNvPr id="42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557" r="29146"/>
            <a:stretch/>
          </p:blipFill>
          <p:spPr>
            <a:xfrm>
              <a:off x="3056394" y="6009787"/>
              <a:ext cx="3785345" cy="3531256"/>
            </a:xfrm>
            <a:prstGeom prst="rect">
              <a:avLst/>
            </a:prstGeom>
          </p:spPr>
        </p:pic>
        <p:sp>
          <p:nvSpPr>
            <p:cNvPr id="43" name="직사각형 42"/>
            <p:cNvSpPr/>
            <p:nvPr/>
          </p:nvSpPr>
          <p:spPr>
            <a:xfrm flipH="1">
              <a:off x="3753131" y="6691696"/>
              <a:ext cx="647937" cy="27173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Atp1a3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49" name="그룹 48"/>
          <p:cNvGrpSpPr/>
          <p:nvPr/>
        </p:nvGrpSpPr>
        <p:grpSpPr>
          <a:xfrm>
            <a:off x="6366262" y="4894027"/>
            <a:ext cx="3696674" cy="3101826"/>
            <a:chOff x="6466677" y="6738708"/>
            <a:chExt cx="3696674" cy="3101826"/>
          </a:xfrm>
        </p:grpSpPr>
        <p:pic>
          <p:nvPicPr>
            <p:cNvPr id="45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519" r="32256"/>
            <a:stretch/>
          </p:blipFill>
          <p:spPr>
            <a:xfrm>
              <a:off x="6466677" y="6738708"/>
              <a:ext cx="3696674" cy="3101826"/>
            </a:xfrm>
            <a:prstGeom prst="rect">
              <a:avLst/>
            </a:prstGeom>
          </p:spPr>
        </p:pic>
        <p:sp>
          <p:nvSpPr>
            <p:cNvPr id="48" name="직사각형 47"/>
            <p:cNvSpPr/>
            <p:nvPr/>
          </p:nvSpPr>
          <p:spPr>
            <a:xfrm>
              <a:off x="7169529" y="6851182"/>
              <a:ext cx="54989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 err="1">
                  <a:solidFill>
                    <a:srgbClr val="00B0F0"/>
                  </a:solidFill>
                </a:rPr>
                <a:t>Ptgfr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sp>
        <p:nvSpPr>
          <p:cNvPr id="4" name="직사각형 3"/>
          <p:cNvSpPr/>
          <p:nvPr/>
        </p:nvSpPr>
        <p:spPr>
          <a:xfrm>
            <a:off x="4655023" y="6966593"/>
            <a:ext cx="66342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err="1">
                <a:solidFill>
                  <a:srgbClr val="00B0F0"/>
                </a:solidFill>
              </a:rPr>
              <a:t>Lipg</a:t>
            </a:r>
            <a:endParaRPr lang="ko-KR" altLang="en-US" sz="1400" b="1" dirty="0">
              <a:solidFill>
                <a:srgbClr val="00B0F0"/>
              </a:solidFill>
            </a:endParaRPr>
          </a:p>
        </p:txBody>
      </p:sp>
      <p:pic>
        <p:nvPicPr>
          <p:cNvPr id="52" name="내용 개체 틀 4">
            <a:extLst>
              <a:ext uri="{FF2B5EF4-FFF2-40B4-BE49-F238E27FC236}">
                <a16:creationId xmlns:a16="http://schemas.microsoft.com/office/drawing/2014/main" id="{098E4CEF-EE37-4285-9510-98FAA694AA6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77" r="26387"/>
          <a:stretch/>
        </p:blipFill>
        <p:spPr>
          <a:xfrm>
            <a:off x="3677681" y="6292384"/>
            <a:ext cx="4145574" cy="3795402"/>
          </a:xfrm>
          <a:prstGeom prst="rect">
            <a:avLst/>
          </a:prstGeom>
        </p:spPr>
      </p:pic>
      <p:grpSp>
        <p:nvGrpSpPr>
          <p:cNvPr id="57" name="그룹 56"/>
          <p:cNvGrpSpPr/>
          <p:nvPr/>
        </p:nvGrpSpPr>
        <p:grpSpPr>
          <a:xfrm>
            <a:off x="5132962" y="9199177"/>
            <a:ext cx="4865910" cy="3550301"/>
            <a:chOff x="6139500" y="9559502"/>
            <a:chExt cx="3474350" cy="2981448"/>
          </a:xfrm>
        </p:grpSpPr>
        <p:pic>
          <p:nvPicPr>
            <p:cNvPr id="54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55" r="20515"/>
            <a:stretch/>
          </p:blipFill>
          <p:spPr>
            <a:xfrm>
              <a:off x="6139500" y="9559502"/>
              <a:ext cx="3474350" cy="2981448"/>
            </a:xfrm>
            <a:prstGeom prst="rect">
              <a:avLst/>
            </a:prstGeom>
          </p:spPr>
        </p:pic>
        <p:sp>
          <p:nvSpPr>
            <p:cNvPr id="56" name="직사각형 55"/>
            <p:cNvSpPr/>
            <p:nvPr/>
          </p:nvSpPr>
          <p:spPr>
            <a:xfrm>
              <a:off x="8497489" y="10642846"/>
              <a:ext cx="534745" cy="25846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Abcb1b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sp>
        <p:nvSpPr>
          <p:cNvPr id="31" name="TextBox 30"/>
          <p:cNvSpPr txBox="1"/>
          <p:nvPr/>
        </p:nvSpPr>
        <p:spPr>
          <a:xfrm>
            <a:off x="281001" y="274651"/>
            <a:ext cx="9075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8. Predictive protein interaction of up- and down-regulated transcripts in the reproductively-aged mouse ovary. </a:t>
            </a:r>
            <a:endParaRPr lang="ko-KR" altLang="en-US" sz="18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427157" y="1032708"/>
            <a:ext cx="428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C)</a:t>
            </a:r>
            <a:endParaRPr lang="ko-KR" altLang="en-US" sz="14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744398" y="1033961"/>
            <a:ext cx="29751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Up-regulation in 15W vs 2W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68418194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그룹 8"/>
          <p:cNvGrpSpPr/>
          <p:nvPr/>
        </p:nvGrpSpPr>
        <p:grpSpPr>
          <a:xfrm>
            <a:off x="5349922" y="473920"/>
            <a:ext cx="4708478" cy="3494924"/>
            <a:chOff x="281001" y="797871"/>
            <a:chExt cx="4708478" cy="3494924"/>
          </a:xfrm>
        </p:grpSpPr>
        <p:pic>
          <p:nvPicPr>
            <p:cNvPr id="6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46" r="21617"/>
            <a:stretch/>
          </p:blipFill>
          <p:spPr>
            <a:xfrm>
              <a:off x="281001" y="797871"/>
              <a:ext cx="4708478" cy="3494924"/>
            </a:xfrm>
            <a:prstGeom prst="rect">
              <a:avLst/>
            </a:prstGeom>
          </p:spPr>
        </p:pic>
        <p:sp>
          <p:nvSpPr>
            <p:cNvPr id="7" name="직사각형 6"/>
            <p:cNvSpPr/>
            <p:nvPr/>
          </p:nvSpPr>
          <p:spPr>
            <a:xfrm>
              <a:off x="3507186" y="2478428"/>
              <a:ext cx="83708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Hsd17b7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11" name="그룹 10"/>
          <p:cNvGrpSpPr/>
          <p:nvPr/>
        </p:nvGrpSpPr>
        <p:grpSpPr>
          <a:xfrm>
            <a:off x="59107" y="811531"/>
            <a:ext cx="3897777" cy="4485857"/>
            <a:chOff x="5415272" y="557987"/>
            <a:chExt cx="3897777" cy="4485857"/>
          </a:xfrm>
        </p:grpSpPr>
        <p:pic>
          <p:nvPicPr>
            <p:cNvPr id="8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344" r="30444"/>
            <a:stretch/>
          </p:blipFill>
          <p:spPr>
            <a:xfrm>
              <a:off x="5415272" y="557987"/>
              <a:ext cx="3897777" cy="4485857"/>
            </a:xfrm>
            <a:prstGeom prst="rect">
              <a:avLst/>
            </a:prstGeom>
          </p:spPr>
        </p:pic>
        <p:sp>
          <p:nvSpPr>
            <p:cNvPr id="10" name="직사각형 9"/>
            <p:cNvSpPr/>
            <p:nvPr/>
          </p:nvSpPr>
          <p:spPr>
            <a:xfrm>
              <a:off x="7332222" y="942707"/>
              <a:ext cx="48269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Star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14" name="그룹 13"/>
          <p:cNvGrpSpPr/>
          <p:nvPr/>
        </p:nvGrpSpPr>
        <p:grpSpPr>
          <a:xfrm>
            <a:off x="3418831" y="2193548"/>
            <a:ext cx="3647294" cy="3280406"/>
            <a:chOff x="6258707" y="5029405"/>
            <a:chExt cx="3647294" cy="3280406"/>
          </a:xfrm>
        </p:grpSpPr>
        <p:pic>
          <p:nvPicPr>
            <p:cNvPr id="12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737" r="32334"/>
            <a:stretch/>
          </p:blipFill>
          <p:spPr>
            <a:xfrm>
              <a:off x="6258707" y="5029405"/>
              <a:ext cx="3647294" cy="3280406"/>
            </a:xfrm>
            <a:prstGeom prst="rect">
              <a:avLst/>
            </a:prstGeom>
          </p:spPr>
        </p:pic>
        <p:sp>
          <p:nvSpPr>
            <p:cNvPr id="13" name="직사각형 12"/>
            <p:cNvSpPr/>
            <p:nvPr/>
          </p:nvSpPr>
          <p:spPr>
            <a:xfrm>
              <a:off x="7019398" y="5130789"/>
              <a:ext cx="57740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Sfrp4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28" name="그룹 27"/>
          <p:cNvGrpSpPr/>
          <p:nvPr/>
        </p:nvGrpSpPr>
        <p:grpSpPr>
          <a:xfrm>
            <a:off x="84617" y="5729634"/>
            <a:ext cx="4006120" cy="3891832"/>
            <a:chOff x="84617" y="5729634"/>
            <a:chExt cx="4006120" cy="3891832"/>
          </a:xfrm>
        </p:grpSpPr>
        <p:pic>
          <p:nvPicPr>
            <p:cNvPr id="16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57" r="26313"/>
            <a:stretch/>
          </p:blipFill>
          <p:spPr>
            <a:xfrm>
              <a:off x="84617" y="5729634"/>
              <a:ext cx="4006120" cy="3891832"/>
            </a:xfrm>
            <a:prstGeom prst="rect">
              <a:avLst/>
            </a:prstGeom>
          </p:spPr>
        </p:pic>
        <p:sp>
          <p:nvSpPr>
            <p:cNvPr id="19" name="직사각형 18"/>
            <p:cNvSpPr/>
            <p:nvPr/>
          </p:nvSpPr>
          <p:spPr>
            <a:xfrm>
              <a:off x="2486904" y="5817062"/>
              <a:ext cx="72327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FF9933"/>
                  </a:solidFill>
                </a:rPr>
                <a:t>S100a8</a:t>
              </a:r>
              <a:endParaRPr lang="ko-KR" altLang="en-US" sz="1400" b="1" dirty="0">
                <a:solidFill>
                  <a:srgbClr val="FF9933"/>
                </a:solidFill>
              </a:endParaRPr>
            </a:p>
          </p:txBody>
        </p:sp>
      </p:grpSp>
      <p:grpSp>
        <p:nvGrpSpPr>
          <p:cNvPr id="27" name="그룹 26"/>
          <p:cNvGrpSpPr/>
          <p:nvPr/>
        </p:nvGrpSpPr>
        <p:grpSpPr>
          <a:xfrm>
            <a:off x="1087609" y="8383901"/>
            <a:ext cx="4278917" cy="4252444"/>
            <a:chOff x="3449293" y="4184434"/>
            <a:chExt cx="3946357" cy="3862041"/>
          </a:xfrm>
        </p:grpSpPr>
        <p:pic>
          <p:nvPicPr>
            <p:cNvPr id="17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365" r="22554"/>
            <a:stretch/>
          </p:blipFill>
          <p:spPr>
            <a:xfrm>
              <a:off x="3449293" y="4184434"/>
              <a:ext cx="3946357" cy="3862041"/>
            </a:xfrm>
            <a:prstGeom prst="rect">
              <a:avLst/>
            </a:prstGeom>
          </p:spPr>
        </p:pic>
        <p:sp>
          <p:nvSpPr>
            <p:cNvPr id="20" name="직사각형 19"/>
            <p:cNvSpPr/>
            <p:nvPr/>
          </p:nvSpPr>
          <p:spPr>
            <a:xfrm>
              <a:off x="4953000" y="4731680"/>
              <a:ext cx="667062" cy="2795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FF9933"/>
                  </a:solidFill>
                </a:rPr>
                <a:t>S100a9</a:t>
              </a:r>
              <a:endParaRPr lang="ko-KR" altLang="en-US" sz="1400" b="1" dirty="0">
                <a:solidFill>
                  <a:srgbClr val="FF9933"/>
                </a:solidFill>
              </a:endParaRPr>
            </a:p>
          </p:txBody>
        </p:sp>
      </p:grpSp>
      <p:grpSp>
        <p:nvGrpSpPr>
          <p:cNvPr id="26" name="그룹 25"/>
          <p:cNvGrpSpPr/>
          <p:nvPr/>
        </p:nvGrpSpPr>
        <p:grpSpPr>
          <a:xfrm>
            <a:off x="5974391" y="5117413"/>
            <a:ext cx="4084009" cy="3797929"/>
            <a:chOff x="5830826" y="5805703"/>
            <a:chExt cx="4084009" cy="3797929"/>
          </a:xfrm>
        </p:grpSpPr>
        <p:pic>
          <p:nvPicPr>
            <p:cNvPr id="18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073" r="29178"/>
            <a:stretch/>
          </p:blipFill>
          <p:spPr>
            <a:xfrm>
              <a:off x="5830826" y="5805703"/>
              <a:ext cx="4084009" cy="3797929"/>
            </a:xfrm>
            <a:prstGeom prst="rect">
              <a:avLst/>
            </a:prstGeom>
          </p:spPr>
        </p:pic>
        <p:sp>
          <p:nvSpPr>
            <p:cNvPr id="21" name="직사각형 20"/>
            <p:cNvSpPr/>
            <p:nvPr/>
          </p:nvSpPr>
          <p:spPr>
            <a:xfrm>
              <a:off x="8710320" y="5952422"/>
              <a:ext cx="49815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FF9933"/>
                  </a:solidFill>
                </a:rPr>
                <a:t>Atf3</a:t>
              </a:r>
              <a:endParaRPr lang="ko-KR" altLang="en-US" sz="1400" b="1" dirty="0">
                <a:solidFill>
                  <a:srgbClr val="FF9933"/>
                </a:solidFill>
              </a:endParaRPr>
            </a:p>
          </p:txBody>
        </p:sp>
      </p:grpSp>
      <p:grpSp>
        <p:nvGrpSpPr>
          <p:cNvPr id="29" name="그룹 28"/>
          <p:cNvGrpSpPr/>
          <p:nvPr/>
        </p:nvGrpSpPr>
        <p:grpSpPr>
          <a:xfrm>
            <a:off x="3354313" y="5264133"/>
            <a:ext cx="4059825" cy="3647301"/>
            <a:chOff x="2847610" y="7825345"/>
            <a:chExt cx="3737076" cy="2569298"/>
          </a:xfrm>
        </p:grpSpPr>
        <p:pic>
          <p:nvPicPr>
            <p:cNvPr id="22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751" r="25391"/>
            <a:stretch/>
          </p:blipFill>
          <p:spPr>
            <a:xfrm>
              <a:off x="2847610" y="7825345"/>
              <a:ext cx="3737076" cy="2569298"/>
            </a:xfrm>
            <a:prstGeom prst="rect">
              <a:avLst/>
            </a:prstGeom>
          </p:spPr>
        </p:pic>
        <p:sp>
          <p:nvSpPr>
            <p:cNvPr id="24" name="직사각형 23"/>
            <p:cNvSpPr/>
            <p:nvPr/>
          </p:nvSpPr>
          <p:spPr>
            <a:xfrm>
              <a:off x="3174743" y="8046475"/>
              <a:ext cx="523340" cy="2168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400" b="1" dirty="0" err="1">
                  <a:solidFill>
                    <a:srgbClr val="FF9933"/>
                  </a:solidFill>
                </a:rPr>
                <a:t>Fosb</a:t>
              </a:r>
              <a:endParaRPr lang="ko-KR" altLang="en-US" sz="1400" b="1" dirty="0">
                <a:solidFill>
                  <a:srgbClr val="FF9933"/>
                </a:solidFill>
              </a:endParaRPr>
            </a:p>
          </p:txBody>
        </p:sp>
      </p:grpSp>
      <p:grpSp>
        <p:nvGrpSpPr>
          <p:cNvPr id="32" name="그룹 31"/>
          <p:cNvGrpSpPr/>
          <p:nvPr/>
        </p:nvGrpSpPr>
        <p:grpSpPr>
          <a:xfrm>
            <a:off x="4579584" y="8592063"/>
            <a:ext cx="4529740" cy="4749985"/>
            <a:chOff x="4761039" y="8633134"/>
            <a:chExt cx="4529740" cy="4749985"/>
          </a:xfrm>
        </p:grpSpPr>
        <p:pic>
          <p:nvPicPr>
            <p:cNvPr id="30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973" r="28794"/>
            <a:stretch/>
          </p:blipFill>
          <p:spPr>
            <a:xfrm>
              <a:off x="4761039" y="8633134"/>
              <a:ext cx="4529740" cy="4749985"/>
            </a:xfrm>
            <a:prstGeom prst="rect">
              <a:avLst/>
            </a:prstGeom>
          </p:spPr>
        </p:pic>
        <p:sp>
          <p:nvSpPr>
            <p:cNvPr id="31" name="직사각형 30"/>
            <p:cNvSpPr/>
            <p:nvPr/>
          </p:nvSpPr>
          <p:spPr>
            <a:xfrm>
              <a:off x="6875549" y="9797261"/>
              <a:ext cx="720043" cy="30772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400" b="1" dirty="0" err="1">
                  <a:solidFill>
                    <a:srgbClr val="FF9933"/>
                  </a:solidFill>
                </a:rPr>
                <a:t>Fos</a:t>
              </a:r>
              <a:endParaRPr lang="ko-KR" altLang="en-US" sz="1400" b="1" dirty="0">
                <a:solidFill>
                  <a:srgbClr val="FF9933"/>
                </a:solidFill>
              </a:endParaRPr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281001" y="274651"/>
            <a:ext cx="9075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8. Predictive protein interaction of up- and down-regulated transcripts in the reproductively-aged mouse ovary. </a:t>
            </a:r>
            <a:endParaRPr lang="ko-KR" altLang="en-US" sz="18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427157" y="5341242"/>
            <a:ext cx="428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)</a:t>
            </a:r>
            <a:endParaRPr lang="ko-KR" altLang="en-US" sz="14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744398" y="5342495"/>
            <a:ext cx="29751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own-regulation in 15W vs 2W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56879681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그룹 10"/>
          <p:cNvGrpSpPr/>
          <p:nvPr/>
        </p:nvGrpSpPr>
        <p:grpSpPr>
          <a:xfrm>
            <a:off x="16042" y="1922311"/>
            <a:ext cx="4405727" cy="3822184"/>
            <a:chOff x="1452716" y="1819251"/>
            <a:chExt cx="3008672" cy="2682770"/>
          </a:xfrm>
        </p:grpSpPr>
        <p:pic>
          <p:nvPicPr>
            <p:cNvPr id="9" name="내용 개체 틀 7">
              <a:extLst>
                <a:ext uri="{FF2B5EF4-FFF2-40B4-BE49-F238E27FC236}">
                  <a16:creationId xmlns:a16="http://schemas.microsoft.com/office/drawing/2014/main" id="{8C2865E9-1C1B-462D-99D7-1F4BCBF633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265" r="17396"/>
            <a:stretch/>
          </p:blipFill>
          <p:spPr>
            <a:xfrm>
              <a:off x="1452716" y="1819251"/>
              <a:ext cx="3008672" cy="2682770"/>
            </a:xfrm>
            <a:prstGeom prst="rect">
              <a:avLst/>
            </a:prstGeom>
          </p:spPr>
        </p:pic>
        <p:sp>
          <p:nvSpPr>
            <p:cNvPr id="10" name="직사각형 9"/>
            <p:cNvSpPr/>
            <p:nvPr/>
          </p:nvSpPr>
          <p:spPr>
            <a:xfrm flipH="1">
              <a:off x="3122982" y="2463351"/>
              <a:ext cx="689475" cy="216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Sprr1a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14" name="그룹 13"/>
          <p:cNvGrpSpPr/>
          <p:nvPr/>
        </p:nvGrpSpPr>
        <p:grpSpPr>
          <a:xfrm>
            <a:off x="6167663" y="1568549"/>
            <a:ext cx="3883340" cy="3816329"/>
            <a:chOff x="6733509" y="1031725"/>
            <a:chExt cx="2809568" cy="2682770"/>
          </a:xfrm>
        </p:grpSpPr>
        <p:pic>
          <p:nvPicPr>
            <p:cNvPr id="12" name="내용 개체 틀 7">
              <a:extLst>
                <a:ext uri="{FF2B5EF4-FFF2-40B4-BE49-F238E27FC236}">
                  <a16:creationId xmlns:a16="http://schemas.microsoft.com/office/drawing/2014/main" id="{8C2865E9-1C1B-462D-99D7-1F4BCBF633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92" r="21598"/>
            <a:stretch/>
          </p:blipFill>
          <p:spPr>
            <a:xfrm>
              <a:off x="6733509" y="1031725"/>
              <a:ext cx="2809568" cy="2682770"/>
            </a:xfrm>
            <a:prstGeom prst="rect">
              <a:avLst/>
            </a:prstGeom>
          </p:spPr>
        </p:pic>
        <p:sp>
          <p:nvSpPr>
            <p:cNvPr id="13" name="직사각형 12"/>
            <p:cNvSpPr/>
            <p:nvPr/>
          </p:nvSpPr>
          <p:spPr>
            <a:xfrm>
              <a:off x="8045245" y="1425071"/>
              <a:ext cx="585417" cy="21635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Wisp2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17" name="그룹 16"/>
          <p:cNvGrpSpPr/>
          <p:nvPr/>
        </p:nvGrpSpPr>
        <p:grpSpPr>
          <a:xfrm>
            <a:off x="3948488" y="2225027"/>
            <a:ext cx="3054716" cy="3385196"/>
            <a:chOff x="4114810" y="1347788"/>
            <a:chExt cx="2219633" cy="2509052"/>
          </a:xfrm>
        </p:grpSpPr>
        <p:pic>
          <p:nvPicPr>
            <p:cNvPr id="15" name="내용 개체 틀 7">
              <a:extLst>
                <a:ext uri="{FF2B5EF4-FFF2-40B4-BE49-F238E27FC236}">
                  <a16:creationId xmlns:a16="http://schemas.microsoft.com/office/drawing/2014/main" id="{8C2865E9-1C1B-462D-99D7-1F4BCBF633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39" r="33531"/>
            <a:stretch/>
          </p:blipFill>
          <p:spPr>
            <a:xfrm>
              <a:off x="4114810" y="1347788"/>
              <a:ext cx="2219633" cy="2509052"/>
            </a:xfrm>
            <a:prstGeom prst="rect">
              <a:avLst/>
            </a:prstGeom>
          </p:spPr>
        </p:pic>
        <p:sp>
          <p:nvSpPr>
            <p:cNvPr id="16" name="직사각형 15"/>
            <p:cNvSpPr/>
            <p:nvPr/>
          </p:nvSpPr>
          <p:spPr>
            <a:xfrm>
              <a:off x="4216285" y="1440460"/>
              <a:ext cx="472856" cy="22811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Mgst2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20" name="그룹 19"/>
          <p:cNvGrpSpPr/>
          <p:nvPr/>
        </p:nvGrpSpPr>
        <p:grpSpPr>
          <a:xfrm>
            <a:off x="5444134" y="5170142"/>
            <a:ext cx="3901286" cy="3734473"/>
            <a:chOff x="461856" y="4546289"/>
            <a:chExt cx="4226264" cy="4197447"/>
          </a:xfrm>
        </p:grpSpPr>
        <p:pic>
          <p:nvPicPr>
            <p:cNvPr id="18" name="내용 개체 틀 6">
              <a:extLst>
                <a:ext uri="{FF2B5EF4-FFF2-40B4-BE49-F238E27FC236}">
                  <a16:creationId xmlns:a16="http://schemas.microsoft.com/office/drawing/2014/main" id="{B42742B9-4BE1-498D-BC30-68B0D9460E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117" r="28609"/>
            <a:stretch/>
          </p:blipFill>
          <p:spPr>
            <a:xfrm>
              <a:off x="461856" y="4546289"/>
              <a:ext cx="4226264" cy="4197447"/>
            </a:xfrm>
            <a:prstGeom prst="rect">
              <a:avLst/>
            </a:prstGeom>
          </p:spPr>
        </p:pic>
        <p:sp>
          <p:nvSpPr>
            <p:cNvPr id="19" name="직사각형 18"/>
            <p:cNvSpPr/>
            <p:nvPr/>
          </p:nvSpPr>
          <p:spPr>
            <a:xfrm flipH="1">
              <a:off x="999222" y="5043040"/>
              <a:ext cx="795977" cy="34593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400" b="1" dirty="0" err="1">
                  <a:solidFill>
                    <a:srgbClr val="00B0F0"/>
                  </a:solidFill>
                </a:rPr>
                <a:t>Inhba</a:t>
              </a:r>
              <a:endParaRPr lang="ko-KR" altLang="en-US" sz="12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23" name="그룹 22"/>
          <p:cNvGrpSpPr/>
          <p:nvPr/>
        </p:nvGrpSpPr>
        <p:grpSpPr>
          <a:xfrm>
            <a:off x="497801" y="5807135"/>
            <a:ext cx="4946333" cy="3366948"/>
            <a:chOff x="4027774" y="4932553"/>
            <a:chExt cx="4946333" cy="3366948"/>
          </a:xfrm>
        </p:grpSpPr>
        <p:pic>
          <p:nvPicPr>
            <p:cNvPr id="21" name="내용 개체 틀 7">
              <a:extLst>
                <a:ext uri="{FF2B5EF4-FFF2-40B4-BE49-F238E27FC236}">
                  <a16:creationId xmlns:a16="http://schemas.microsoft.com/office/drawing/2014/main" id="{7924FDEE-5A88-444D-85B8-E511A32C37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752" r="24073"/>
            <a:stretch/>
          </p:blipFill>
          <p:spPr>
            <a:xfrm>
              <a:off x="4027774" y="4932553"/>
              <a:ext cx="4946333" cy="3366948"/>
            </a:xfrm>
            <a:prstGeom prst="rect">
              <a:avLst/>
            </a:prstGeom>
          </p:spPr>
        </p:pic>
        <p:sp>
          <p:nvSpPr>
            <p:cNvPr id="22" name="직사각형 21"/>
            <p:cNvSpPr/>
            <p:nvPr/>
          </p:nvSpPr>
          <p:spPr>
            <a:xfrm>
              <a:off x="7358450" y="6459706"/>
              <a:ext cx="79380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Akr1c18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sp>
        <p:nvSpPr>
          <p:cNvPr id="24" name="직사각형 23"/>
          <p:cNvSpPr/>
          <p:nvPr/>
        </p:nvSpPr>
        <p:spPr>
          <a:xfrm>
            <a:off x="5750468" y="2614635"/>
            <a:ext cx="13612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solidFill>
                  <a:srgbClr val="00B0F0"/>
                </a:solidFill>
              </a:rPr>
              <a:t>H2-T9(Gm7030)</a:t>
            </a:r>
            <a:endParaRPr lang="ko-KR" altLang="en-US" sz="1400" b="1" dirty="0">
              <a:solidFill>
                <a:srgbClr val="00B0F0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81001" y="274651"/>
            <a:ext cx="9075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8. Predictive protein interaction of up- and down-regulated transcripts in the reproductively-aged mouse ovary. </a:t>
            </a:r>
            <a:endParaRPr lang="ko-KR" altLang="en-US" sz="18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427157" y="1032708"/>
            <a:ext cx="428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E)</a:t>
            </a:r>
            <a:endParaRPr lang="ko-KR" altLang="en-US" sz="14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744398" y="1033961"/>
            <a:ext cx="29751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Up-regulation in 20W vs 2W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51193039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그룹 11"/>
          <p:cNvGrpSpPr/>
          <p:nvPr/>
        </p:nvGrpSpPr>
        <p:grpSpPr>
          <a:xfrm>
            <a:off x="3636986" y="1887538"/>
            <a:ext cx="3126073" cy="2815468"/>
            <a:chOff x="3172591" y="1678665"/>
            <a:chExt cx="2682239" cy="2460637"/>
          </a:xfrm>
        </p:grpSpPr>
        <p:pic>
          <p:nvPicPr>
            <p:cNvPr id="10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709" r="32987"/>
            <a:stretch/>
          </p:blipFill>
          <p:spPr>
            <a:xfrm>
              <a:off x="3172591" y="1678665"/>
              <a:ext cx="2682239" cy="2460637"/>
            </a:xfrm>
            <a:prstGeom prst="rect">
              <a:avLst/>
            </a:prstGeom>
          </p:spPr>
        </p:pic>
        <p:sp>
          <p:nvSpPr>
            <p:cNvPr id="11" name="직사각형 10"/>
            <p:cNvSpPr/>
            <p:nvPr/>
          </p:nvSpPr>
          <p:spPr>
            <a:xfrm>
              <a:off x="3470899" y="1809470"/>
              <a:ext cx="517430" cy="2689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Eif3j1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15" name="그룹 14"/>
          <p:cNvGrpSpPr/>
          <p:nvPr/>
        </p:nvGrpSpPr>
        <p:grpSpPr>
          <a:xfrm>
            <a:off x="6738134" y="1887538"/>
            <a:ext cx="3167865" cy="2844800"/>
            <a:chOff x="6545180" y="1887538"/>
            <a:chExt cx="2823056" cy="2407736"/>
          </a:xfrm>
        </p:grpSpPr>
        <p:pic>
          <p:nvPicPr>
            <p:cNvPr id="13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434" r="27787"/>
            <a:stretch/>
          </p:blipFill>
          <p:spPr>
            <a:xfrm>
              <a:off x="6545180" y="1887538"/>
              <a:ext cx="2823056" cy="2407736"/>
            </a:xfrm>
            <a:prstGeom prst="rect">
              <a:avLst/>
            </a:prstGeom>
          </p:spPr>
        </p:pic>
        <p:sp>
          <p:nvSpPr>
            <p:cNvPr id="14" name="직사각형 13"/>
            <p:cNvSpPr/>
            <p:nvPr/>
          </p:nvSpPr>
          <p:spPr>
            <a:xfrm>
              <a:off x="6545180" y="2680532"/>
              <a:ext cx="561695" cy="26049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Nme2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19" name="그룹 18"/>
          <p:cNvGrpSpPr/>
          <p:nvPr/>
        </p:nvGrpSpPr>
        <p:grpSpPr>
          <a:xfrm>
            <a:off x="641161" y="5796119"/>
            <a:ext cx="4245115" cy="4022380"/>
            <a:chOff x="744398" y="5569295"/>
            <a:chExt cx="3634957" cy="3577907"/>
          </a:xfrm>
        </p:grpSpPr>
        <p:pic>
          <p:nvPicPr>
            <p:cNvPr id="17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755" r="18560"/>
            <a:stretch/>
          </p:blipFill>
          <p:spPr>
            <a:xfrm>
              <a:off x="744398" y="5569295"/>
              <a:ext cx="3634957" cy="3577907"/>
            </a:xfrm>
            <a:prstGeom prst="rect">
              <a:avLst/>
            </a:prstGeom>
          </p:spPr>
        </p:pic>
        <p:sp>
          <p:nvSpPr>
            <p:cNvPr id="18" name="직사각형 17"/>
            <p:cNvSpPr/>
            <p:nvPr/>
          </p:nvSpPr>
          <p:spPr>
            <a:xfrm>
              <a:off x="1054356" y="6272774"/>
              <a:ext cx="572649" cy="27376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FF9933"/>
                  </a:solidFill>
                </a:rPr>
                <a:t>Plac9a</a:t>
              </a:r>
              <a:endParaRPr lang="ko-KR" altLang="en-US" sz="1400" b="1" dirty="0">
                <a:solidFill>
                  <a:srgbClr val="FF9933"/>
                </a:solidFill>
              </a:endParaRPr>
            </a:p>
          </p:txBody>
        </p:sp>
      </p:grpSp>
      <p:grpSp>
        <p:nvGrpSpPr>
          <p:cNvPr id="21" name="그룹 20"/>
          <p:cNvGrpSpPr/>
          <p:nvPr/>
        </p:nvGrpSpPr>
        <p:grpSpPr>
          <a:xfrm>
            <a:off x="362415" y="1951795"/>
            <a:ext cx="2997866" cy="2745289"/>
            <a:chOff x="362415" y="1951795"/>
            <a:chExt cx="2997866" cy="2745289"/>
          </a:xfrm>
        </p:grpSpPr>
        <p:pic>
          <p:nvPicPr>
            <p:cNvPr id="6" name="내용 개체 틀 4">
              <a:extLst>
                <a:ext uri="{FF2B5EF4-FFF2-40B4-BE49-F238E27FC236}">
                  <a16:creationId xmlns:a16="http://schemas.microsoft.com/office/drawing/2014/main" id="{098E4CEF-EE37-4285-9510-98FAA694AA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33" r="29814"/>
            <a:stretch/>
          </p:blipFill>
          <p:spPr>
            <a:xfrm>
              <a:off x="686827" y="1951795"/>
              <a:ext cx="2673454" cy="2745289"/>
            </a:xfrm>
            <a:prstGeom prst="rect">
              <a:avLst/>
            </a:prstGeom>
          </p:spPr>
        </p:pic>
        <p:sp>
          <p:nvSpPr>
            <p:cNvPr id="20" name="직사각형 19"/>
            <p:cNvSpPr/>
            <p:nvPr/>
          </p:nvSpPr>
          <p:spPr>
            <a:xfrm>
              <a:off x="362415" y="3090757"/>
              <a:ext cx="127111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Tgoln1(Tgoln2)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281001" y="274651"/>
            <a:ext cx="9075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8. Predictive protein interaction of up- and down-regulated transcripts in the  reproductively-aged mouse ovary. </a:t>
            </a:r>
            <a:endParaRPr lang="ko-KR" altLang="en-US" sz="18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27157" y="1032708"/>
            <a:ext cx="428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F)</a:t>
            </a:r>
            <a:endParaRPr lang="ko-KR" altLang="en-US" sz="14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744398" y="1033961"/>
            <a:ext cx="41418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Up- and down-regulation in 15W vs 6W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96076241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그룹 8"/>
          <p:cNvGrpSpPr/>
          <p:nvPr/>
        </p:nvGrpSpPr>
        <p:grpSpPr>
          <a:xfrm>
            <a:off x="946898" y="1242658"/>
            <a:ext cx="3978443" cy="4351338"/>
            <a:chOff x="427157" y="1425071"/>
            <a:chExt cx="3978443" cy="4351338"/>
          </a:xfrm>
        </p:grpSpPr>
        <p:pic>
          <p:nvPicPr>
            <p:cNvPr id="6" name="내용 개체 틀 9">
              <a:extLst>
                <a:ext uri="{FF2B5EF4-FFF2-40B4-BE49-F238E27FC236}">
                  <a16:creationId xmlns:a16="http://schemas.microsoft.com/office/drawing/2014/main" id="{85CAD686-C3A7-4098-8F97-C0AB144715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637" r="23589"/>
            <a:stretch/>
          </p:blipFill>
          <p:spPr>
            <a:xfrm>
              <a:off x="427157" y="1425071"/>
              <a:ext cx="3978443" cy="4351338"/>
            </a:xfrm>
            <a:prstGeom prst="rect">
              <a:avLst/>
            </a:prstGeom>
          </p:spPr>
        </p:pic>
        <p:sp>
          <p:nvSpPr>
            <p:cNvPr id="7" name="직사각형 6"/>
            <p:cNvSpPr/>
            <p:nvPr/>
          </p:nvSpPr>
          <p:spPr>
            <a:xfrm>
              <a:off x="2416378" y="2349482"/>
              <a:ext cx="57900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FF9933"/>
                  </a:solidFill>
                </a:rPr>
                <a:t>Oog1</a:t>
              </a:r>
              <a:endParaRPr lang="ko-KR" altLang="en-US" sz="1400" b="1" dirty="0">
                <a:solidFill>
                  <a:srgbClr val="FF9933"/>
                </a:solidFill>
              </a:endParaRPr>
            </a:p>
          </p:txBody>
        </p:sp>
      </p:grpSp>
      <p:grpSp>
        <p:nvGrpSpPr>
          <p:cNvPr id="13" name="그룹 12"/>
          <p:cNvGrpSpPr/>
          <p:nvPr/>
        </p:nvGrpSpPr>
        <p:grpSpPr>
          <a:xfrm>
            <a:off x="1281778" y="6162191"/>
            <a:ext cx="3707735" cy="2841478"/>
            <a:chOff x="462533" y="1678665"/>
            <a:chExt cx="3707735" cy="2841478"/>
          </a:xfrm>
        </p:grpSpPr>
        <p:pic>
          <p:nvPicPr>
            <p:cNvPr id="14" name="내용 개체 틀 7">
              <a:extLst>
                <a:ext uri="{FF2B5EF4-FFF2-40B4-BE49-F238E27FC236}">
                  <a16:creationId xmlns:a16="http://schemas.microsoft.com/office/drawing/2014/main" id="{DC58F5E1-C16B-448C-8F42-12C28D0131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561" r="29234"/>
            <a:stretch/>
          </p:blipFill>
          <p:spPr>
            <a:xfrm>
              <a:off x="462533" y="1678665"/>
              <a:ext cx="3707735" cy="2841478"/>
            </a:xfrm>
            <a:prstGeom prst="rect">
              <a:avLst/>
            </a:prstGeom>
          </p:spPr>
        </p:pic>
        <p:sp>
          <p:nvSpPr>
            <p:cNvPr id="15" name="직사각형 14"/>
            <p:cNvSpPr/>
            <p:nvPr/>
          </p:nvSpPr>
          <p:spPr>
            <a:xfrm>
              <a:off x="3119150" y="2609367"/>
              <a:ext cx="56848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Cxcl1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16" name="그룹 15"/>
          <p:cNvGrpSpPr/>
          <p:nvPr/>
        </p:nvGrpSpPr>
        <p:grpSpPr>
          <a:xfrm>
            <a:off x="5379238" y="6162191"/>
            <a:ext cx="4066482" cy="2780199"/>
            <a:chOff x="4257090" y="1563571"/>
            <a:chExt cx="4066482" cy="2780199"/>
          </a:xfrm>
        </p:grpSpPr>
        <p:pic>
          <p:nvPicPr>
            <p:cNvPr id="17" name="내용 개체 틀 7">
              <a:extLst>
                <a:ext uri="{FF2B5EF4-FFF2-40B4-BE49-F238E27FC236}">
                  <a16:creationId xmlns:a16="http://schemas.microsoft.com/office/drawing/2014/main" id="{DCE1A4BB-F47B-4D05-A6DA-D1CAF4F458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598" r="28697"/>
            <a:stretch/>
          </p:blipFill>
          <p:spPr>
            <a:xfrm>
              <a:off x="4257090" y="1563571"/>
              <a:ext cx="4066482" cy="2780199"/>
            </a:xfrm>
            <a:prstGeom prst="rect">
              <a:avLst/>
            </a:prstGeom>
          </p:spPr>
        </p:pic>
        <p:sp>
          <p:nvSpPr>
            <p:cNvPr id="18" name="직사각형 17"/>
            <p:cNvSpPr/>
            <p:nvPr/>
          </p:nvSpPr>
          <p:spPr>
            <a:xfrm>
              <a:off x="7410341" y="2190812"/>
              <a:ext cx="73449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Hspa1a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19" name="그룹 18"/>
          <p:cNvGrpSpPr/>
          <p:nvPr/>
        </p:nvGrpSpPr>
        <p:grpSpPr>
          <a:xfrm>
            <a:off x="659601" y="8807916"/>
            <a:ext cx="4488038" cy="3306622"/>
            <a:chOff x="191069" y="4682048"/>
            <a:chExt cx="3753134" cy="2968634"/>
          </a:xfrm>
        </p:grpSpPr>
        <p:pic>
          <p:nvPicPr>
            <p:cNvPr id="20" name="내용 개체 틀 6">
              <a:extLst>
                <a:ext uri="{FF2B5EF4-FFF2-40B4-BE49-F238E27FC236}">
                  <a16:creationId xmlns:a16="http://schemas.microsoft.com/office/drawing/2014/main" id="{B9B92EA4-52E0-44D2-9F5A-0A024B9E4B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429" r="25983"/>
            <a:stretch/>
          </p:blipFill>
          <p:spPr>
            <a:xfrm>
              <a:off x="191069" y="4682048"/>
              <a:ext cx="3753134" cy="2968634"/>
            </a:xfrm>
            <a:prstGeom prst="rect">
              <a:avLst/>
            </a:prstGeom>
          </p:spPr>
        </p:pic>
        <p:sp>
          <p:nvSpPr>
            <p:cNvPr id="21" name="직사각형 20"/>
            <p:cNvSpPr/>
            <p:nvPr/>
          </p:nvSpPr>
          <p:spPr>
            <a:xfrm>
              <a:off x="2326080" y="5645970"/>
              <a:ext cx="654441" cy="27631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Hspa1b 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</p:grpSp>
      <p:grpSp>
        <p:nvGrpSpPr>
          <p:cNvPr id="3" name="그룹 2"/>
          <p:cNvGrpSpPr/>
          <p:nvPr/>
        </p:nvGrpSpPr>
        <p:grpSpPr>
          <a:xfrm>
            <a:off x="5412448" y="8935571"/>
            <a:ext cx="3944203" cy="3361544"/>
            <a:chOff x="5412448" y="8935571"/>
            <a:chExt cx="3944203" cy="3361544"/>
          </a:xfrm>
        </p:grpSpPr>
        <p:sp>
          <p:nvSpPr>
            <p:cNvPr id="23" name="직사각형 22"/>
            <p:cNvSpPr/>
            <p:nvPr/>
          </p:nvSpPr>
          <p:spPr>
            <a:xfrm>
              <a:off x="5705875" y="10811530"/>
              <a:ext cx="60625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solidFill>
                    <a:srgbClr val="00B0F0"/>
                  </a:solidFill>
                </a:rPr>
                <a:t>Zfp36</a:t>
              </a:r>
              <a:endParaRPr lang="ko-KR" altLang="en-US" sz="1400" b="1" dirty="0">
                <a:solidFill>
                  <a:srgbClr val="00B0F0"/>
                </a:solidFill>
              </a:endParaRPr>
            </a:p>
          </p:txBody>
        </p:sp>
        <p:pic>
          <p:nvPicPr>
            <p:cNvPr id="24" name="내용 개체 틀 11">
              <a:extLst>
                <a:ext uri="{FF2B5EF4-FFF2-40B4-BE49-F238E27FC236}">
                  <a16:creationId xmlns:a16="http://schemas.microsoft.com/office/drawing/2014/main" id="{90DF7094-C6BA-4A20-B257-A1ABC4BD39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84" r="23806"/>
            <a:stretch/>
          </p:blipFill>
          <p:spPr>
            <a:xfrm>
              <a:off x="5412448" y="8935571"/>
              <a:ext cx="3944203" cy="3361544"/>
            </a:xfrm>
            <a:prstGeom prst="rect">
              <a:avLst/>
            </a:prstGeom>
          </p:spPr>
        </p:pic>
      </p:grpSp>
      <p:sp>
        <p:nvSpPr>
          <p:cNvPr id="25" name="TextBox 24"/>
          <p:cNvSpPr txBox="1"/>
          <p:nvPr/>
        </p:nvSpPr>
        <p:spPr>
          <a:xfrm>
            <a:off x="281001" y="274651"/>
            <a:ext cx="9075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8. Predictive protein interaction of up- and down-regulated transcripts in the reproductively-aged mouse ovary. </a:t>
            </a:r>
            <a:endParaRPr lang="ko-KR" altLang="en-US" sz="18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427157" y="1032708"/>
            <a:ext cx="428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G)</a:t>
            </a:r>
            <a:endParaRPr lang="ko-KR" altLang="en-US" sz="14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744398" y="1033961"/>
            <a:ext cx="41418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own-regulation in 20W vs 6W</a:t>
            </a:r>
            <a:endParaRPr lang="ko-KR" altLang="en-US" sz="14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440075" y="5834598"/>
            <a:ext cx="428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H)</a:t>
            </a:r>
            <a:endParaRPr lang="ko-KR" altLang="en-US" sz="14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757316" y="5835851"/>
            <a:ext cx="41418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Up-regulation in 20W vs 15W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5096481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81001" y="274651"/>
            <a:ext cx="89111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Supple Fig 3. </a:t>
            </a:r>
            <a:r>
              <a:rPr lang="en-US" altLang="ko-KR" sz="1800" b="1" dirty="0" err="1"/>
              <a:t>ctsGE</a:t>
            </a:r>
            <a:r>
              <a:rPr lang="en-US" altLang="ko-KR" sz="1800" b="1" dirty="0"/>
              <a:t> distribution of transcripts </a:t>
            </a:r>
            <a:r>
              <a:rPr lang="en-US" altLang="ko-KR" sz="1800" b="1" dirty="0">
                <a:solidFill>
                  <a:srgbClr val="3333FF"/>
                </a:solidFill>
              </a:rPr>
              <a:t>in the reproductively-aged mouse ovary</a:t>
            </a:r>
            <a:r>
              <a:rPr lang="en-US" altLang="ko-KR" sz="1800" b="1" dirty="0"/>
              <a:t>. </a:t>
            </a:r>
            <a:endParaRPr lang="ko-KR" altLang="en-US" sz="1800" b="1" dirty="0"/>
          </a:p>
        </p:txBody>
      </p:sp>
      <p:pic>
        <p:nvPicPr>
          <p:cNvPr id="3" name="그림 2"/>
          <p:cNvPicPr preferRelativeResize="0">
            <a:picLocks/>
          </p:cNvPicPr>
          <p:nvPr/>
        </p:nvPicPr>
        <p:blipFill rotWithShape="1">
          <a:blip r:embed="rId2"/>
          <a:srcRect r="1223"/>
          <a:stretch/>
        </p:blipFill>
        <p:spPr>
          <a:xfrm>
            <a:off x="5240620" y="1541851"/>
            <a:ext cx="4320000" cy="4320000"/>
          </a:xfrm>
          <a:prstGeom prst="rect">
            <a:avLst/>
          </a:prstGeom>
        </p:spPr>
      </p:pic>
      <p:pic>
        <p:nvPicPr>
          <p:cNvPr id="4" name="그림 3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5241513" y="6879097"/>
            <a:ext cx="4320000" cy="4320000"/>
          </a:xfrm>
          <a:prstGeom prst="rect">
            <a:avLst/>
          </a:prstGeom>
        </p:spPr>
      </p:pic>
      <p:pic>
        <p:nvPicPr>
          <p:cNvPr id="5" name="그림 4"/>
          <p:cNvPicPr preferRelativeResize="0">
            <a:picLocks/>
          </p:cNvPicPr>
          <p:nvPr/>
        </p:nvPicPr>
        <p:blipFill rotWithShape="1">
          <a:blip r:embed="rId4"/>
          <a:srcRect l="486"/>
          <a:stretch/>
        </p:blipFill>
        <p:spPr>
          <a:xfrm>
            <a:off x="556692" y="1541851"/>
            <a:ext cx="4320000" cy="4320000"/>
          </a:xfrm>
          <a:prstGeom prst="rect">
            <a:avLst/>
          </a:prstGeom>
        </p:spPr>
      </p:pic>
      <p:pic>
        <p:nvPicPr>
          <p:cNvPr id="7" name="그림 6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570335" y="6890605"/>
            <a:ext cx="4320000" cy="43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45083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5091" y="1554690"/>
            <a:ext cx="4212000" cy="4399697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10071" y="1623247"/>
            <a:ext cx="4320000" cy="4331139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7091" y="6899353"/>
            <a:ext cx="4320000" cy="4291801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895624" y="7084736"/>
            <a:ext cx="318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g)</a:t>
            </a:r>
            <a:endParaRPr lang="ko-KR" altLang="en-US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281001" y="274651"/>
            <a:ext cx="89111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3. </a:t>
            </a:r>
            <a:r>
              <a:rPr lang="en-US" altLang="ko-KR" sz="1800" b="1" dirty="0" err="1"/>
              <a:t>ctsGE</a:t>
            </a:r>
            <a:r>
              <a:rPr lang="en-US" altLang="ko-KR" sz="1800" b="1" dirty="0"/>
              <a:t> distribution of transcripts in the reproductively-aged mouse ovary. </a:t>
            </a:r>
            <a:endParaRPr lang="ko-KR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29184918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1001" y="274651"/>
            <a:ext cx="7082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4. GOBP analyses of the reproductively-aged mouse ovary. </a:t>
            </a:r>
            <a:endParaRPr lang="ko-KR" altLang="en-US" sz="1800" b="1" dirty="0"/>
          </a:p>
        </p:txBody>
      </p:sp>
      <p:grpSp>
        <p:nvGrpSpPr>
          <p:cNvPr id="7" name="그룹 6"/>
          <p:cNvGrpSpPr/>
          <p:nvPr/>
        </p:nvGrpSpPr>
        <p:grpSpPr>
          <a:xfrm>
            <a:off x="978192" y="1486546"/>
            <a:ext cx="8640000" cy="3591394"/>
            <a:chOff x="1018937" y="4136787"/>
            <a:chExt cx="8440617" cy="2840314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8938" y="4163562"/>
              <a:ext cx="8440616" cy="2813539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018937" y="4136787"/>
              <a:ext cx="1467295" cy="2190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a) 6W vs 2W_all</a:t>
              </a:r>
              <a:endParaRPr lang="ko-KR" altLang="en-US" sz="1200" b="1" dirty="0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</a:t>
            </a:r>
            <a:endParaRPr lang="ko-KR" altLang="en-US" sz="1400" b="1" dirty="0"/>
          </a:p>
        </p:txBody>
      </p:sp>
      <p:pic>
        <p:nvPicPr>
          <p:cNvPr id="11" name="그림 10"/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135" y="5365753"/>
            <a:ext cx="8852444" cy="3814955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971102" y="5298792"/>
            <a:ext cx="1467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) 6W vs 2W_up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8003850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846" y="5245492"/>
            <a:ext cx="8863074" cy="370600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81001" y="274651"/>
            <a:ext cx="7082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4. GOBP analyses of the reproductively-aged mouse ovary. </a:t>
            </a:r>
            <a:endParaRPr lang="ko-KR" altLang="en-US" sz="1800" b="1" dirty="0"/>
          </a:p>
        </p:txBody>
      </p:sp>
      <p:grpSp>
        <p:nvGrpSpPr>
          <p:cNvPr id="7" name="그룹 6"/>
          <p:cNvGrpSpPr/>
          <p:nvPr/>
        </p:nvGrpSpPr>
        <p:grpSpPr>
          <a:xfrm>
            <a:off x="978192" y="1161081"/>
            <a:ext cx="8640000" cy="3639520"/>
            <a:chOff x="1018937" y="4136787"/>
            <a:chExt cx="8440617" cy="2840314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8938" y="4163562"/>
              <a:ext cx="8440616" cy="2813539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018937" y="4136787"/>
              <a:ext cx="1467295" cy="2161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/>
                <a:t>a) 15W vs 2W_all</a:t>
              </a:r>
              <a:endParaRPr lang="ko-KR" altLang="en-US" sz="1200" b="1" dirty="0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B</a:t>
            </a:r>
            <a:endParaRPr lang="ko-KR" alt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971102" y="5225988"/>
            <a:ext cx="1467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) 15W vs 2W_up</a:t>
            </a:r>
            <a:endParaRPr lang="ko-KR" altLang="en-US" sz="1200" b="1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846" y="9236242"/>
            <a:ext cx="8863074" cy="349317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979119" y="9228499"/>
            <a:ext cx="20585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) 15W vs 2W_down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5723408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그림 1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505" y="8918361"/>
            <a:ext cx="8863075" cy="3582447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238" y="4784554"/>
            <a:ext cx="8861342" cy="3657380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238" y="1177968"/>
            <a:ext cx="8861342" cy="340606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78192" y="1161087"/>
            <a:ext cx="1501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a) 20W vs 2W_all</a:t>
            </a:r>
            <a:endParaRPr lang="ko-KR" alt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C</a:t>
            </a:r>
            <a:endParaRPr lang="ko-KR" alt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971102" y="4804876"/>
            <a:ext cx="1467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) 20W vs 2W_up</a:t>
            </a:r>
            <a:endParaRPr lang="ko-KR" altLang="en-US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979121" y="8963800"/>
            <a:ext cx="21050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) 20W vs 2W_down</a:t>
            </a:r>
            <a:endParaRPr lang="ko-KR" altLang="en-US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81001" y="274651"/>
            <a:ext cx="7082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4. GOBP analyses of the reproductively-aged mouse ovary. </a:t>
            </a:r>
            <a:endParaRPr lang="ko-KR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6315409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504" y="8894926"/>
            <a:ext cx="8851044" cy="3859882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238" y="5286146"/>
            <a:ext cx="8849309" cy="3438410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504" y="1202032"/>
            <a:ext cx="8851043" cy="360092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78192" y="1161087"/>
            <a:ext cx="1501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a) 15W vs 6W_all</a:t>
            </a:r>
            <a:endParaRPr lang="ko-KR" alt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D</a:t>
            </a:r>
            <a:endParaRPr lang="ko-KR" alt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971102" y="5286146"/>
            <a:ext cx="1467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) 15W vs 6W_up</a:t>
            </a:r>
            <a:endParaRPr lang="ko-KR" altLang="en-US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979121" y="8915681"/>
            <a:ext cx="219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) 15W vs 6W_down</a:t>
            </a:r>
            <a:endParaRPr lang="ko-KR" altLang="en-US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81001" y="274651"/>
            <a:ext cx="7082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4. GOBP analyses of the reproductively-aged mouse ovary. </a:t>
            </a:r>
            <a:endParaRPr lang="ko-KR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17848374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6070" y="8935186"/>
            <a:ext cx="8873373" cy="3349056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505" y="5053263"/>
            <a:ext cx="8875105" cy="3629534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237" y="1159628"/>
            <a:ext cx="8873373" cy="365215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78192" y="1161087"/>
            <a:ext cx="1501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a) 20W vs 6W_all</a:t>
            </a:r>
            <a:endParaRPr lang="ko-KR" alt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563529" y="925033"/>
            <a:ext cx="31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E</a:t>
            </a:r>
            <a:endParaRPr lang="ko-KR" alt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971102" y="5033478"/>
            <a:ext cx="1467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b) 20W vs 6W_up</a:t>
            </a:r>
            <a:endParaRPr lang="ko-KR" altLang="en-US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839637" y="8869187"/>
            <a:ext cx="1841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c) 20W vs 6W_down</a:t>
            </a:r>
            <a:endParaRPr lang="ko-KR" altLang="en-US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81001" y="274651"/>
            <a:ext cx="7082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/>
              <a:t>Figure S4. GOBP analyses of the reproductively-aged mouse ovary. </a:t>
            </a:r>
            <a:endParaRPr lang="ko-KR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34882034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16</TotalTime>
  <Words>822</Words>
  <Application>Microsoft Office PowerPoint</Application>
  <PresentationFormat>Custom</PresentationFormat>
  <Paragraphs>162</Paragraphs>
  <Slides>2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8</vt:i4>
      </vt:variant>
    </vt:vector>
  </HeadingPairs>
  <TitlesOfParts>
    <vt:vector size="33" baseType="lpstr">
      <vt:lpstr>맑은 고딕</vt:lpstr>
      <vt:lpstr>Arial</vt:lpstr>
      <vt:lpstr>Calibri</vt:lpstr>
      <vt:lpstr>Calibri Light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oony</dc:creator>
  <cp:lastModifiedBy>MDPI</cp:lastModifiedBy>
  <cp:revision>147</cp:revision>
  <cp:lastPrinted>2021-04-24T07:19:29Z</cp:lastPrinted>
  <dcterms:created xsi:type="dcterms:W3CDTF">2021-03-28T04:56:26Z</dcterms:created>
  <dcterms:modified xsi:type="dcterms:W3CDTF">2021-10-09T10:05:56Z</dcterms:modified>
</cp:coreProperties>
</file>